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1259D0-1EAD-429A-BE5F-0D14171DD8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D1AB7-702D-4311-8882-43D8CEC232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56B143-599E-4FE9-B63D-DBE5AC7B36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BD7B1-983B-4616-AC0F-DAA689BBCC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1AD73-DF55-4460-BC26-27CAFDF3F3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CBAE4-2EA3-40D6-8F62-93D6535D7A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744A8-9599-4C6D-A7BD-B2589C2603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EAC34-0878-4816-B0EA-5DFB84FD5C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7B89B-5E19-4268-91C8-D7063D60A4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C1CB62-2947-409D-91BA-2760BB9D99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CFDA6-B24D-4408-99D5-8D9CF5DD11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F5E0E-B378-46D0-9817-E4118D557C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56B47B-604D-45AA-9977-B2896CE14E8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2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2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2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2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2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2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33200" y="260496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684360" y="1174680"/>
            <a:ext cx="7561080" cy="393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2 mg of plasma from five healthy individuals (Normal 1-5) and five cirrhotic patients (Cirrhosis 1-5) were separated by 9-16% 2-DE using pH 3-5.6NL IPG strip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Differentially expressed features along with their Swiss-Prot entry names are highlighte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, feature present only in gels with plasma from normal healthy contro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, feature present only in gels with plasma from cirrhotic patien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*, features present in both healthy and cirrhotic plasma but expressed to a higher extent in the group indica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5" name=""/>
          <p:cNvSpPr/>
          <p:nvPr/>
        </p:nvSpPr>
        <p:spPr>
          <a:xfrm>
            <a:off x="110880" y="4428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irrhosis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6" name="" descr=""/>
          <p:cNvPicPr/>
          <p:nvPr/>
        </p:nvPicPr>
        <p:blipFill>
          <a:blip r:embed="rId1"/>
          <a:srcRect l="2995" t="531" r="4838" b="0"/>
          <a:stretch/>
        </p:blipFill>
        <p:spPr>
          <a:xfrm>
            <a:off x="2050920" y="896760"/>
            <a:ext cx="5042160" cy="5053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97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"/>
          <p:cNvSpPr/>
          <p:nvPr/>
        </p:nvSpPr>
        <p:spPr>
          <a:xfrm>
            <a:off x="1671120" y="29242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2" name=""/>
          <p:cNvSpPr/>
          <p:nvPr/>
        </p:nvSpPr>
        <p:spPr>
          <a:xfrm flipH="1">
            <a:off x="4655880" y="1117440"/>
            <a:ext cx="423720" cy="586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"/>
          <p:cNvSpPr/>
          <p:nvPr/>
        </p:nvSpPr>
        <p:spPr>
          <a:xfrm flipH="1">
            <a:off x="4800600" y="1117440"/>
            <a:ext cx="495360" cy="586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"/>
          <p:cNvSpPr/>
          <p:nvPr/>
        </p:nvSpPr>
        <p:spPr>
          <a:xfrm>
            <a:off x="4878000" y="93348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"/>
          <p:cNvSpPr/>
          <p:nvPr/>
        </p:nvSpPr>
        <p:spPr>
          <a:xfrm flipH="1">
            <a:off x="4817880" y="1141560"/>
            <a:ext cx="787320" cy="861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"/>
          <p:cNvSpPr/>
          <p:nvPr/>
        </p:nvSpPr>
        <p:spPr>
          <a:xfrm>
            <a:off x="5555160" y="932040"/>
            <a:ext cx="965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"/>
          <p:cNvSpPr/>
          <p:nvPr/>
        </p:nvSpPr>
        <p:spPr>
          <a:xfrm flipH="1">
            <a:off x="5167080" y="1351080"/>
            <a:ext cx="788760" cy="164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"/>
          <p:cNvSpPr/>
          <p:nvPr/>
        </p:nvSpPr>
        <p:spPr>
          <a:xfrm>
            <a:off x="5894280" y="121608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"/>
          <p:cNvSpPr/>
          <p:nvPr/>
        </p:nvSpPr>
        <p:spPr>
          <a:xfrm flipH="1">
            <a:off x="5973480" y="3033720"/>
            <a:ext cx="547560" cy="442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"/>
          <p:cNvSpPr/>
          <p:nvPr/>
        </p:nvSpPr>
        <p:spPr>
          <a:xfrm>
            <a:off x="6441120" y="288612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"/>
          <p:cNvSpPr/>
          <p:nvPr/>
        </p:nvSpPr>
        <p:spPr>
          <a:xfrm>
            <a:off x="2627280" y="4721400"/>
            <a:ext cx="298440" cy="64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"/>
          <p:cNvSpPr/>
          <p:nvPr/>
        </p:nvSpPr>
        <p:spPr>
          <a:xfrm flipV="1">
            <a:off x="2638440" y="4901760"/>
            <a:ext cx="468360" cy="179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"/>
          <p:cNvSpPr/>
          <p:nvPr/>
        </p:nvSpPr>
        <p:spPr>
          <a:xfrm>
            <a:off x="2051640" y="461484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"/>
          <p:cNvSpPr/>
          <p:nvPr/>
        </p:nvSpPr>
        <p:spPr>
          <a:xfrm>
            <a:off x="4253040" y="4894200"/>
            <a:ext cx="40932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"/>
          <p:cNvSpPr/>
          <p:nvPr/>
        </p:nvSpPr>
        <p:spPr>
          <a:xfrm>
            <a:off x="3705120" y="480384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"/>
          <p:cNvSpPr/>
          <p:nvPr/>
        </p:nvSpPr>
        <p:spPr>
          <a:xfrm flipV="1">
            <a:off x="4786200" y="5181120"/>
            <a:ext cx="214560" cy="427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"/>
          <p:cNvSpPr/>
          <p:nvPr/>
        </p:nvSpPr>
        <p:spPr>
          <a:xfrm>
            <a:off x="4501440" y="559440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"/>
          <p:cNvSpPr/>
          <p:nvPr/>
        </p:nvSpPr>
        <p:spPr>
          <a:xfrm flipH="1" flipV="1">
            <a:off x="5670360" y="5219640"/>
            <a:ext cx="253800" cy="316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"/>
          <p:cNvSpPr/>
          <p:nvPr/>
        </p:nvSpPr>
        <p:spPr>
          <a:xfrm>
            <a:off x="5858640" y="548316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"/>
          <p:cNvSpPr/>
          <p:nvPr/>
        </p:nvSpPr>
        <p:spPr>
          <a:xfrm flipV="1">
            <a:off x="6335640" y="5195520"/>
            <a:ext cx="201600" cy="405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"/>
          <p:cNvSpPr/>
          <p:nvPr/>
        </p:nvSpPr>
        <p:spPr>
          <a:xfrm flipH="1">
            <a:off x="6080040" y="3735360"/>
            <a:ext cx="303120" cy="101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"/>
          <p:cNvSpPr/>
          <p:nvPr/>
        </p:nvSpPr>
        <p:spPr>
          <a:xfrm>
            <a:off x="6315120" y="3524400"/>
            <a:ext cx="692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"/>
          <p:cNvSpPr/>
          <p:nvPr/>
        </p:nvSpPr>
        <p:spPr>
          <a:xfrm flipH="1">
            <a:off x="6021000" y="3986280"/>
            <a:ext cx="422280" cy="109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"/>
          <p:cNvSpPr/>
          <p:nvPr/>
        </p:nvSpPr>
        <p:spPr>
          <a:xfrm>
            <a:off x="6383880" y="387504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"/>
          <p:cNvSpPr/>
          <p:nvPr/>
        </p:nvSpPr>
        <p:spPr>
          <a:xfrm>
            <a:off x="2032920" y="439092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"/>
          <p:cNvSpPr/>
          <p:nvPr/>
        </p:nvSpPr>
        <p:spPr>
          <a:xfrm flipV="1">
            <a:off x="2397240" y="429264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"/>
          <p:cNvSpPr/>
          <p:nvPr/>
        </p:nvSpPr>
        <p:spPr>
          <a:xfrm flipV="1">
            <a:off x="2655720" y="3255480"/>
            <a:ext cx="738360" cy="5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8" name=""/>
          <p:cNvSpPr/>
          <p:nvPr/>
        </p:nvSpPr>
        <p:spPr>
          <a:xfrm>
            <a:off x="2090520" y="368136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"/>
          <p:cNvSpPr/>
          <p:nvPr/>
        </p:nvSpPr>
        <p:spPr>
          <a:xfrm flipH="1" flipV="1">
            <a:off x="4257720" y="3490920"/>
            <a:ext cx="9360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"/>
          <p:cNvSpPr/>
          <p:nvPr/>
        </p:nvSpPr>
        <p:spPr>
          <a:xfrm>
            <a:off x="4206600" y="36100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"/>
          <p:cNvSpPr/>
          <p:nvPr/>
        </p:nvSpPr>
        <p:spPr>
          <a:xfrm flipH="1" flipV="1">
            <a:off x="4676400" y="3986280"/>
            <a:ext cx="11160" cy="388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"/>
          <p:cNvSpPr/>
          <p:nvPr/>
        </p:nvSpPr>
        <p:spPr>
          <a:xfrm>
            <a:off x="3870360" y="435780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"/>
          <p:cNvSpPr/>
          <p:nvPr/>
        </p:nvSpPr>
        <p:spPr>
          <a:xfrm flipV="1">
            <a:off x="4227480" y="3895200"/>
            <a:ext cx="133560" cy="297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4" name=""/>
          <p:cNvSpPr/>
          <p:nvPr/>
        </p:nvSpPr>
        <p:spPr>
          <a:xfrm>
            <a:off x="3852000" y="414504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5" name=""/>
          <p:cNvSpPr/>
          <p:nvPr/>
        </p:nvSpPr>
        <p:spPr>
          <a:xfrm>
            <a:off x="2627280" y="2927520"/>
            <a:ext cx="250920" cy="266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6" name=""/>
          <p:cNvSpPr/>
          <p:nvPr/>
        </p:nvSpPr>
        <p:spPr>
          <a:xfrm flipV="1">
            <a:off x="2690640" y="3236400"/>
            <a:ext cx="235080" cy="28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7" name=""/>
          <p:cNvSpPr/>
          <p:nvPr/>
        </p:nvSpPr>
        <p:spPr>
          <a:xfrm>
            <a:off x="2204640" y="271152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8" name=""/>
          <p:cNvSpPr/>
          <p:nvPr/>
        </p:nvSpPr>
        <p:spPr>
          <a:xfrm>
            <a:off x="2043000" y="345276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9" name=""/>
          <p:cNvSpPr/>
          <p:nvPr/>
        </p:nvSpPr>
        <p:spPr>
          <a:xfrm>
            <a:off x="3803760" y="2303640"/>
            <a:ext cx="4680" cy="534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0" name=""/>
          <p:cNvSpPr/>
          <p:nvPr/>
        </p:nvSpPr>
        <p:spPr>
          <a:xfrm>
            <a:off x="3465360" y="212580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1" name=""/>
          <p:cNvSpPr/>
          <p:nvPr/>
        </p:nvSpPr>
        <p:spPr>
          <a:xfrm flipH="1">
            <a:off x="5425920" y="2532240"/>
            <a:ext cx="998640" cy="699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2" name=""/>
          <p:cNvSpPr/>
          <p:nvPr/>
        </p:nvSpPr>
        <p:spPr>
          <a:xfrm>
            <a:off x="6367680" y="239400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3" name=""/>
          <p:cNvSpPr/>
          <p:nvPr/>
        </p:nvSpPr>
        <p:spPr>
          <a:xfrm flipH="1">
            <a:off x="5698800" y="3367080"/>
            <a:ext cx="693720" cy="550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"/>
          <p:cNvSpPr/>
          <p:nvPr/>
        </p:nvSpPr>
        <p:spPr>
          <a:xfrm>
            <a:off x="6325560" y="326556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"/>
          <p:cNvSpPr/>
          <p:nvPr/>
        </p:nvSpPr>
        <p:spPr>
          <a:xfrm>
            <a:off x="3720960" y="1179360"/>
            <a:ext cx="250920" cy="594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6" name=""/>
          <p:cNvSpPr/>
          <p:nvPr/>
        </p:nvSpPr>
        <p:spPr>
          <a:xfrm>
            <a:off x="3296520" y="955800"/>
            <a:ext cx="56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TIH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7" name=""/>
          <p:cNvSpPr/>
          <p:nvPr/>
        </p:nvSpPr>
        <p:spPr>
          <a:xfrm flipH="1">
            <a:off x="5770080" y="2190600"/>
            <a:ext cx="530280" cy="578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8" name=""/>
          <p:cNvSpPr/>
          <p:nvPr/>
        </p:nvSpPr>
        <p:spPr>
          <a:xfrm>
            <a:off x="6227640" y="2027160"/>
            <a:ext cx="936720" cy="33732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V304,HV30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9" name=""/>
          <p:cNvSpPr/>
          <p:nvPr/>
        </p:nvSpPr>
        <p:spPr>
          <a:xfrm>
            <a:off x="4336920" y="1177920"/>
            <a:ext cx="547920" cy="2040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0" name=""/>
          <p:cNvSpPr/>
          <p:nvPr/>
        </p:nvSpPr>
        <p:spPr>
          <a:xfrm>
            <a:off x="3925440" y="99360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1" name=""/>
          <p:cNvSpPr/>
          <p:nvPr/>
        </p:nvSpPr>
        <p:spPr>
          <a:xfrm flipH="1">
            <a:off x="5138640" y="1600200"/>
            <a:ext cx="874800" cy="16365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2" name=""/>
          <p:cNvSpPr/>
          <p:nvPr/>
        </p:nvSpPr>
        <p:spPr>
          <a:xfrm>
            <a:off x="5943600" y="1514520"/>
            <a:ext cx="586080" cy="21564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"/>
          <p:cNvSpPr/>
          <p:nvPr/>
        </p:nvSpPr>
        <p:spPr>
          <a:xfrm>
            <a:off x="2638440" y="5211720"/>
            <a:ext cx="21096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4" name=""/>
          <p:cNvSpPr/>
          <p:nvPr/>
        </p:nvSpPr>
        <p:spPr>
          <a:xfrm>
            <a:off x="2307960" y="510696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5" name=""/>
          <p:cNvSpPr/>
          <p:nvPr/>
        </p:nvSpPr>
        <p:spPr>
          <a:xfrm>
            <a:off x="6018120" y="1765440"/>
            <a:ext cx="100800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"/>
          <p:cNvSpPr/>
          <p:nvPr/>
        </p:nvSpPr>
        <p:spPr>
          <a:xfrm flipH="1">
            <a:off x="5167440" y="1843200"/>
            <a:ext cx="909360" cy="15094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7" name=""/>
          <p:cNvSpPr/>
          <p:nvPr/>
        </p:nvSpPr>
        <p:spPr>
          <a:xfrm flipV="1">
            <a:off x="5265720" y="4193640"/>
            <a:ext cx="298440" cy="162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"/>
          <p:cNvSpPr/>
          <p:nvPr/>
        </p:nvSpPr>
        <p:spPr>
          <a:xfrm>
            <a:off x="4778640" y="386244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"/>
          <p:cNvSpPr/>
          <p:nvPr/>
        </p:nvSpPr>
        <p:spPr>
          <a:xfrm flipH="1" flipV="1">
            <a:off x="5362200" y="5229360"/>
            <a:ext cx="73080" cy="234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"/>
          <p:cNvSpPr/>
          <p:nvPr/>
        </p:nvSpPr>
        <p:spPr>
          <a:xfrm>
            <a:off x="5148000" y="543564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"/>
          <p:cNvSpPr/>
          <p:nvPr/>
        </p:nvSpPr>
        <p:spPr>
          <a:xfrm>
            <a:off x="2061360" y="496584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"/>
          <p:cNvSpPr/>
          <p:nvPr/>
        </p:nvSpPr>
        <p:spPr>
          <a:xfrm>
            <a:off x="2061360" y="482112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"/>
          <p:cNvSpPr/>
          <p:nvPr/>
        </p:nvSpPr>
        <p:spPr>
          <a:xfrm flipV="1">
            <a:off x="2637000" y="4861080"/>
            <a:ext cx="280800" cy="47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4" name=""/>
          <p:cNvSpPr/>
          <p:nvPr/>
        </p:nvSpPr>
        <p:spPr>
          <a:xfrm>
            <a:off x="3143160" y="4994280"/>
            <a:ext cx="4856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5" name=""/>
          <p:cNvSpPr/>
          <p:nvPr/>
        </p:nvSpPr>
        <p:spPr>
          <a:xfrm flipH="1" flipV="1">
            <a:off x="3241440" y="4795920"/>
            <a:ext cx="73080" cy="249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6" name=""/>
          <p:cNvSpPr/>
          <p:nvPr/>
        </p:nvSpPr>
        <p:spPr>
          <a:xfrm flipH="1" flipV="1">
            <a:off x="3357360" y="4479480"/>
            <a:ext cx="50760" cy="544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7" name=""/>
          <p:cNvSpPr/>
          <p:nvPr/>
        </p:nvSpPr>
        <p:spPr>
          <a:xfrm>
            <a:off x="3186000" y="4241880"/>
            <a:ext cx="50760" cy="195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"/>
          <p:cNvSpPr/>
          <p:nvPr/>
        </p:nvSpPr>
        <p:spPr>
          <a:xfrm flipH="1">
            <a:off x="3120840" y="4240080"/>
            <a:ext cx="20520" cy="182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9" name=""/>
          <p:cNvSpPr/>
          <p:nvPr/>
        </p:nvSpPr>
        <p:spPr>
          <a:xfrm flipH="1">
            <a:off x="3030480" y="4221000"/>
            <a:ext cx="60480" cy="177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0" name=""/>
          <p:cNvSpPr/>
          <p:nvPr/>
        </p:nvSpPr>
        <p:spPr>
          <a:xfrm>
            <a:off x="2908440" y="407664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1" name=""/>
          <p:cNvSpPr/>
          <p:nvPr/>
        </p:nvSpPr>
        <p:spPr>
          <a:xfrm flipH="1" flipV="1">
            <a:off x="5867280" y="4384800"/>
            <a:ext cx="301680" cy="255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2" name=""/>
          <p:cNvSpPr/>
          <p:nvPr/>
        </p:nvSpPr>
        <p:spPr>
          <a:xfrm>
            <a:off x="6018840" y="4591080"/>
            <a:ext cx="10065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"/>
          <p:cNvSpPr/>
          <p:nvPr/>
        </p:nvSpPr>
        <p:spPr>
          <a:xfrm>
            <a:off x="3856680" y="506556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4" name=""/>
          <p:cNvSpPr/>
          <p:nvPr/>
        </p:nvSpPr>
        <p:spPr>
          <a:xfrm flipV="1">
            <a:off x="4740120" y="4479480"/>
            <a:ext cx="128880" cy="652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5" name=""/>
          <p:cNvSpPr/>
          <p:nvPr/>
        </p:nvSpPr>
        <p:spPr>
          <a:xfrm flipV="1">
            <a:off x="3824280" y="1800000"/>
            <a:ext cx="322200" cy="352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6" name=""/>
          <p:cNvSpPr/>
          <p:nvPr/>
        </p:nvSpPr>
        <p:spPr>
          <a:xfrm flipH="1" flipV="1">
            <a:off x="3537000" y="4201920"/>
            <a:ext cx="162000" cy="446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7" name=""/>
          <p:cNvSpPr/>
          <p:nvPr/>
        </p:nvSpPr>
        <p:spPr>
          <a:xfrm>
            <a:off x="3542760" y="460548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8" name=""/>
          <p:cNvSpPr/>
          <p:nvPr/>
        </p:nvSpPr>
        <p:spPr>
          <a:xfrm flipV="1">
            <a:off x="2757600" y="3519000"/>
            <a:ext cx="969840" cy="47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9" name=""/>
          <p:cNvSpPr/>
          <p:nvPr/>
        </p:nvSpPr>
        <p:spPr>
          <a:xfrm>
            <a:off x="2268720" y="391644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0" name=""/>
          <p:cNvSpPr/>
          <p:nvPr/>
        </p:nvSpPr>
        <p:spPr>
          <a:xfrm flipV="1">
            <a:off x="3591000" y="3596760"/>
            <a:ext cx="476280" cy="235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1" name=""/>
          <p:cNvSpPr/>
          <p:nvPr/>
        </p:nvSpPr>
        <p:spPr>
          <a:xfrm>
            <a:off x="3310200" y="3800520"/>
            <a:ext cx="529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2" name=""/>
          <p:cNvSpPr/>
          <p:nvPr/>
        </p:nvSpPr>
        <p:spPr>
          <a:xfrm flipH="1" flipV="1">
            <a:off x="4943160" y="3696840"/>
            <a:ext cx="312840" cy="1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3" name=""/>
          <p:cNvSpPr/>
          <p:nvPr/>
        </p:nvSpPr>
        <p:spPr>
          <a:xfrm>
            <a:off x="5191920" y="361152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4" name=""/>
          <p:cNvSpPr/>
          <p:nvPr/>
        </p:nvSpPr>
        <p:spPr>
          <a:xfrm>
            <a:off x="110880" y="4428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irrhosis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5" name="" descr=""/>
          <p:cNvPicPr/>
          <p:nvPr/>
        </p:nvPicPr>
        <p:blipFill>
          <a:blip r:embed="rId1"/>
          <a:srcRect l="5080" t="0" r="3540" b="4624"/>
          <a:stretch/>
        </p:blipFill>
        <p:spPr>
          <a:xfrm>
            <a:off x="2050920" y="907920"/>
            <a:ext cx="5042160" cy="5042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86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7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8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9" name=""/>
          <p:cNvSpPr/>
          <p:nvPr/>
        </p:nvSpPr>
        <p:spPr>
          <a:xfrm>
            <a:off x="1671120" y="29242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0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1" name=""/>
          <p:cNvSpPr/>
          <p:nvPr/>
        </p:nvSpPr>
        <p:spPr>
          <a:xfrm flipH="1">
            <a:off x="4684680" y="1125360"/>
            <a:ext cx="247680" cy="5209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2" name=""/>
          <p:cNvSpPr/>
          <p:nvPr/>
        </p:nvSpPr>
        <p:spPr>
          <a:xfrm flipH="1">
            <a:off x="4829040" y="1125360"/>
            <a:ext cx="247680" cy="5209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3" name=""/>
          <p:cNvSpPr/>
          <p:nvPr/>
        </p:nvSpPr>
        <p:spPr>
          <a:xfrm>
            <a:off x="4736520" y="94464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4" name=""/>
          <p:cNvSpPr/>
          <p:nvPr/>
        </p:nvSpPr>
        <p:spPr>
          <a:xfrm flipH="1">
            <a:off x="4884480" y="1197000"/>
            <a:ext cx="623880" cy="7174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5" name=""/>
          <p:cNvSpPr/>
          <p:nvPr/>
        </p:nvSpPr>
        <p:spPr>
          <a:xfrm>
            <a:off x="5336280" y="903240"/>
            <a:ext cx="965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6" name=""/>
          <p:cNvSpPr/>
          <p:nvPr/>
        </p:nvSpPr>
        <p:spPr>
          <a:xfrm flipH="1">
            <a:off x="5224320" y="1306440"/>
            <a:ext cx="789120" cy="164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7" name=""/>
          <p:cNvSpPr/>
          <p:nvPr/>
        </p:nvSpPr>
        <p:spPr>
          <a:xfrm>
            <a:off x="5932440" y="115416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8" name=""/>
          <p:cNvSpPr/>
          <p:nvPr/>
        </p:nvSpPr>
        <p:spPr>
          <a:xfrm flipH="1">
            <a:off x="6078240" y="3014640"/>
            <a:ext cx="547560" cy="442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9" name=""/>
          <p:cNvSpPr/>
          <p:nvPr/>
        </p:nvSpPr>
        <p:spPr>
          <a:xfrm>
            <a:off x="6584040" y="290520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0" name=""/>
          <p:cNvSpPr/>
          <p:nvPr/>
        </p:nvSpPr>
        <p:spPr>
          <a:xfrm>
            <a:off x="2685960" y="4692600"/>
            <a:ext cx="298440" cy="6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1" name=""/>
          <p:cNvSpPr/>
          <p:nvPr/>
        </p:nvSpPr>
        <p:spPr>
          <a:xfrm flipV="1">
            <a:off x="2697120" y="4873680"/>
            <a:ext cx="468360" cy="179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2" name=""/>
          <p:cNvSpPr/>
          <p:nvPr/>
        </p:nvSpPr>
        <p:spPr>
          <a:xfrm>
            <a:off x="2110680" y="458640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3" name=""/>
          <p:cNvSpPr/>
          <p:nvPr/>
        </p:nvSpPr>
        <p:spPr>
          <a:xfrm>
            <a:off x="4319640" y="4849920"/>
            <a:ext cx="40968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4" name=""/>
          <p:cNvSpPr/>
          <p:nvPr/>
        </p:nvSpPr>
        <p:spPr>
          <a:xfrm>
            <a:off x="3771720" y="475920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5" name=""/>
          <p:cNvSpPr/>
          <p:nvPr/>
        </p:nvSpPr>
        <p:spPr>
          <a:xfrm flipV="1">
            <a:off x="4938840" y="5103720"/>
            <a:ext cx="214200" cy="426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6" name=""/>
          <p:cNvSpPr/>
          <p:nvPr/>
        </p:nvSpPr>
        <p:spPr>
          <a:xfrm>
            <a:off x="4793400" y="551664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7" name=""/>
          <p:cNvSpPr/>
          <p:nvPr/>
        </p:nvSpPr>
        <p:spPr>
          <a:xfrm flipH="1" flipV="1">
            <a:off x="5786280" y="5127480"/>
            <a:ext cx="254160" cy="316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8" name=""/>
          <p:cNvSpPr/>
          <p:nvPr/>
        </p:nvSpPr>
        <p:spPr>
          <a:xfrm>
            <a:off x="5969880" y="537228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"/>
          <p:cNvSpPr/>
          <p:nvPr/>
        </p:nvSpPr>
        <p:spPr>
          <a:xfrm flipV="1">
            <a:off x="6462720" y="5122800"/>
            <a:ext cx="185760" cy="333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0" name=""/>
          <p:cNvSpPr/>
          <p:nvPr/>
        </p:nvSpPr>
        <p:spPr>
          <a:xfrm flipH="1">
            <a:off x="6197760" y="3706920"/>
            <a:ext cx="271440" cy="112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"/>
          <p:cNvSpPr/>
          <p:nvPr/>
        </p:nvSpPr>
        <p:spPr>
          <a:xfrm>
            <a:off x="6410160" y="3524400"/>
            <a:ext cx="692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2" name=""/>
          <p:cNvSpPr/>
          <p:nvPr/>
        </p:nvSpPr>
        <p:spPr>
          <a:xfrm flipH="1" flipV="1">
            <a:off x="6137280" y="3995280"/>
            <a:ext cx="363600" cy="1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3" name=""/>
          <p:cNvSpPr/>
          <p:nvPr/>
        </p:nvSpPr>
        <p:spPr>
          <a:xfrm>
            <a:off x="6469560" y="388476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4" name=""/>
          <p:cNvSpPr/>
          <p:nvPr/>
        </p:nvSpPr>
        <p:spPr>
          <a:xfrm>
            <a:off x="2004480" y="437184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5" name=""/>
          <p:cNvSpPr/>
          <p:nvPr/>
        </p:nvSpPr>
        <p:spPr>
          <a:xfrm flipV="1">
            <a:off x="2368440" y="427356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6" name=""/>
          <p:cNvSpPr/>
          <p:nvPr/>
        </p:nvSpPr>
        <p:spPr>
          <a:xfrm flipV="1">
            <a:off x="2693880" y="3207960"/>
            <a:ext cx="738360" cy="5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7" name=""/>
          <p:cNvSpPr/>
          <p:nvPr/>
        </p:nvSpPr>
        <p:spPr>
          <a:xfrm>
            <a:off x="2128680" y="363384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8" name=""/>
          <p:cNvSpPr/>
          <p:nvPr/>
        </p:nvSpPr>
        <p:spPr>
          <a:xfrm flipH="1" flipV="1">
            <a:off x="4352400" y="3424320"/>
            <a:ext cx="9396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9" name=""/>
          <p:cNvSpPr/>
          <p:nvPr/>
        </p:nvSpPr>
        <p:spPr>
          <a:xfrm>
            <a:off x="4302000" y="35434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0" name=""/>
          <p:cNvSpPr/>
          <p:nvPr/>
        </p:nvSpPr>
        <p:spPr>
          <a:xfrm flipH="1" flipV="1">
            <a:off x="4762080" y="3889440"/>
            <a:ext cx="11160" cy="388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1" name=""/>
          <p:cNvSpPr/>
          <p:nvPr/>
        </p:nvSpPr>
        <p:spPr>
          <a:xfrm>
            <a:off x="3987720" y="423216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2" name=""/>
          <p:cNvSpPr/>
          <p:nvPr/>
        </p:nvSpPr>
        <p:spPr>
          <a:xfrm flipV="1">
            <a:off x="4313160" y="3838680"/>
            <a:ext cx="133560" cy="296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3" name=""/>
          <p:cNvSpPr/>
          <p:nvPr/>
        </p:nvSpPr>
        <p:spPr>
          <a:xfrm>
            <a:off x="3937680" y="408780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"/>
          <p:cNvSpPr/>
          <p:nvPr/>
        </p:nvSpPr>
        <p:spPr>
          <a:xfrm>
            <a:off x="2627280" y="2889360"/>
            <a:ext cx="250920" cy="266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"/>
          <p:cNvSpPr/>
          <p:nvPr/>
        </p:nvSpPr>
        <p:spPr>
          <a:xfrm flipV="1">
            <a:off x="2690640" y="3198960"/>
            <a:ext cx="235080" cy="288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"/>
          <p:cNvSpPr/>
          <p:nvPr/>
        </p:nvSpPr>
        <p:spPr>
          <a:xfrm>
            <a:off x="2204640" y="267336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"/>
          <p:cNvSpPr/>
          <p:nvPr/>
        </p:nvSpPr>
        <p:spPr>
          <a:xfrm>
            <a:off x="2043000" y="341460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"/>
          <p:cNvSpPr/>
          <p:nvPr/>
        </p:nvSpPr>
        <p:spPr>
          <a:xfrm>
            <a:off x="3889440" y="2236680"/>
            <a:ext cx="4680" cy="534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"/>
          <p:cNvSpPr/>
          <p:nvPr/>
        </p:nvSpPr>
        <p:spPr>
          <a:xfrm>
            <a:off x="3551040" y="205884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"/>
          <p:cNvSpPr/>
          <p:nvPr/>
        </p:nvSpPr>
        <p:spPr>
          <a:xfrm flipH="1">
            <a:off x="5476680" y="2511360"/>
            <a:ext cx="890280" cy="684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"/>
          <p:cNvSpPr/>
          <p:nvPr/>
        </p:nvSpPr>
        <p:spPr>
          <a:xfrm>
            <a:off x="6367680" y="239400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"/>
          <p:cNvSpPr/>
          <p:nvPr/>
        </p:nvSpPr>
        <p:spPr>
          <a:xfrm flipH="1">
            <a:off x="5778360" y="3411360"/>
            <a:ext cx="711360" cy="451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"/>
          <p:cNvSpPr/>
          <p:nvPr/>
        </p:nvSpPr>
        <p:spPr>
          <a:xfrm>
            <a:off x="6441480" y="328464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"/>
          <p:cNvSpPr/>
          <p:nvPr/>
        </p:nvSpPr>
        <p:spPr>
          <a:xfrm>
            <a:off x="3778200" y="1084320"/>
            <a:ext cx="250920" cy="593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5" name=""/>
          <p:cNvSpPr/>
          <p:nvPr/>
        </p:nvSpPr>
        <p:spPr>
          <a:xfrm>
            <a:off x="3277440" y="946080"/>
            <a:ext cx="56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TIH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6" name=""/>
          <p:cNvSpPr/>
          <p:nvPr/>
        </p:nvSpPr>
        <p:spPr>
          <a:xfrm flipH="1">
            <a:off x="5762160" y="2190600"/>
            <a:ext cx="538200" cy="478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7" name=""/>
          <p:cNvSpPr/>
          <p:nvPr/>
        </p:nvSpPr>
        <p:spPr>
          <a:xfrm>
            <a:off x="6227640" y="2027160"/>
            <a:ext cx="936720" cy="33732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V304,HV30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8" name=""/>
          <p:cNvSpPr/>
          <p:nvPr/>
        </p:nvSpPr>
        <p:spPr>
          <a:xfrm>
            <a:off x="4413240" y="1111320"/>
            <a:ext cx="547560" cy="2039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9" name=""/>
          <p:cNvSpPr/>
          <p:nvPr/>
        </p:nvSpPr>
        <p:spPr>
          <a:xfrm>
            <a:off x="4001760" y="92700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0" name=""/>
          <p:cNvSpPr/>
          <p:nvPr/>
        </p:nvSpPr>
        <p:spPr>
          <a:xfrm flipH="1">
            <a:off x="5195520" y="1625760"/>
            <a:ext cx="857160" cy="1530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1" name=""/>
          <p:cNvSpPr/>
          <p:nvPr/>
        </p:nvSpPr>
        <p:spPr>
          <a:xfrm>
            <a:off x="6010200" y="1457280"/>
            <a:ext cx="586080" cy="21564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2" name=""/>
          <p:cNvSpPr/>
          <p:nvPr/>
        </p:nvSpPr>
        <p:spPr>
          <a:xfrm>
            <a:off x="2687760" y="5211720"/>
            <a:ext cx="21096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3" name=""/>
          <p:cNvSpPr/>
          <p:nvPr/>
        </p:nvSpPr>
        <p:spPr>
          <a:xfrm>
            <a:off x="2356920" y="510696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4" name=""/>
          <p:cNvSpPr/>
          <p:nvPr/>
        </p:nvSpPr>
        <p:spPr>
          <a:xfrm>
            <a:off x="6066000" y="1765440"/>
            <a:ext cx="100800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5" name=""/>
          <p:cNvSpPr/>
          <p:nvPr/>
        </p:nvSpPr>
        <p:spPr>
          <a:xfrm flipH="1">
            <a:off x="5248440" y="1905120"/>
            <a:ext cx="855360" cy="1358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6" name=""/>
          <p:cNvSpPr/>
          <p:nvPr/>
        </p:nvSpPr>
        <p:spPr>
          <a:xfrm flipV="1">
            <a:off x="5332320" y="4137120"/>
            <a:ext cx="298440" cy="15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7" name=""/>
          <p:cNvSpPr/>
          <p:nvPr/>
        </p:nvSpPr>
        <p:spPr>
          <a:xfrm>
            <a:off x="4845600" y="380520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8" name=""/>
          <p:cNvSpPr/>
          <p:nvPr/>
        </p:nvSpPr>
        <p:spPr>
          <a:xfrm flipH="1" flipV="1">
            <a:off x="5466960" y="5133600"/>
            <a:ext cx="73080" cy="235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9" name=""/>
          <p:cNvSpPr/>
          <p:nvPr/>
        </p:nvSpPr>
        <p:spPr>
          <a:xfrm>
            <a:off x="5214960" y="53290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0" name=""/>
          <p:cNvSpPr/>
          <p:nvPr/>
        </p:nvSpPr>
        <p:spPr>
          <a:xfrm>
            <a:off x="2120040" y="493704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"/>
          <p:cNvSpPr/>
          <p:nvPr/>
        </p:nvSpPr>
        <p:spPr>
          <a:xfrm>
            <a:off x="2120040" y="479268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"/>
          <p:cNvSpPr/>
          <p:nvPr/>
        </p:nvSpPr>
        <p:spPr>
          <a:xfrm flipV="1">
            <a:off x="2695680" y="4832280"/>
            <a:ext cx="280800" cy="47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"/>
          <p:cNvSpPr/>
          <p:nvPr/>
        </p:nvSpPr>
        <p:spPr>
          <a:xfrm>
            <a:off x="3300480" y="4962600"/>
            <a:ext cx="4856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"/>
          <p:cNvSpPr/>
          <p:nvPr/>
        </p:nvSpPr>
        <p:spPr>
          <a:xfrm flipH="1" flipV="1">
            <a:off x="3336480" y="4762440"/>
            <a:ext cx="73080" cy="249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"/>
          <p:cNvSpPr/>
          <p:nvPr/>
        </p:nvSpPr>
        <p:spPr>
          <a:xfrm flipH="1" flipV="1">
            <a:off x="3452400" y="4446720"/>
            <a:ext cx="50760" cy="544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"/>
          <p:cNvSpPr/>
          <p:nvPr/>
        </p:nvSpPr>
        <p:spPr>
          <a:xfrm>
            <a:off x="3252960" y="4241880"/>
            <a:ext cx="50760" cy="195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"/>
          <p:cNvSpPr/>
          <p:nvPr/>
        </p:nvSpPr>
        <p:spPr>
          <a:xfrm flipH="1">
            <a:off x="3187440" y="4240080"/>
            <a:ext cx="20520" cy="182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8" name=""/>
          <p:cNvSpPr/>
          <p:nvPr/>
        </p:nvSpPr>
        <p:spPr>
          <a:xfrm flipH="1">
            <a:off x="3097080" y="4221000"/>
            <a:ext cx="60480" cy="177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"/>
          <p:cNvSpPr/>
          <p:nvPr/>
        </p:nvSpPr>
        <p:spPr>
          <a:xfrm>
            <a:off x="2936880" y="407664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"/>
          <p:cNvSpPr/>
          <p:nvPr/>
        </p:nvSpPr>
        <p:spPr>
          <a:xfrm flipH="1" flipV="1">
            <a:off x="6011640" y="4327200"/>
            <a:ext cx="323640" cy="2998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"/>
          <p:cNvSpPr/>
          <p:nvPr/>
        </p:nvSpPr>
        <p:spPr>
          <a:xfrm>
            <a:off x="6165000" y="4610160"/>
            <a:ext cx="10065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2" name=""/>
          <p:cNvSpPr/>
          <p:nvPr/>
        </p:nvSpPr>
        <p:spPr>
          <a:xfrm>
            <a:off x="3980520" y="497988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3" name=""/>
          <p:cNvSpPr/>
          <p:nvPr/>
        </p:nvSpPr>
        <p:spPr>
          <a:xfrm flipV="1">
            <a:off x="4863960" y="4393800"/>
            <a:ext cx="128880" cy="652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4" name=""/>
          <p:cNvSpPr/>
          <p:nvPr/>
        </p:nvSpPr>
        <p:spPr>
          <a:xfrm flipV="1">
            <a:off x="3909960" y="1715760"/>
            <a:ext cx="297000" cy="369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"/>
          <p:cNvSpPr/>
          <p:nvPr/>
        </p:nvSpPr>
        <p:spPr>
          <a:xfrm flipH="1" flipV="1">
            <a:off x="3627360" y="4173120"/>
            <a:ext cx="162000" cy="446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"/>
          <p:cNvSpPr/>
          <p:nvPr/>
        </p:nvSpPr>
        <p:spPr>
          <a:xfrm>
            <a:off x="3633120" y="457668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"/>
          <p:cNvSpPr/>
          <p:nvPr/>
        </p:nvSpPr>
        <p:spPr>
          <a:xfrm flipV="1">
            <a:off x="2843280" y="3443040"/>
            <a:ext cx="969840" cy="47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"/>
          <p:cNvSpPr/>
          <p:nvPr/>
        </p:nvSpPr>
        <p:spPr>
          <a:xfrm>
            <a:off x="2354400" y="384012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9" name=""/>
          <p:cNvSpPr/>
          <p:nvPr/>
        </p:nvSpPr>
        <p:spPr>
          <a:xfrm flipV="1">
            <a:off x="3657600" y="3530160"/>
            <a:ext cx="476280" cy="235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0" name=""/>
          <p:cNvSpPr/>
          <p:nvPr/>
        </p:nvSpPr>
        <p:spPr>
          <a:xfrm>
            <a:off x="3376800" y="3733920"/>
            <a:ext cx="529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1" name=""/>
          <p:cNvSpPr/>
          <p:nvPr/>
        </p:nvSpPr>
        <p:spPr>
          <a:xfrm flipH="1" flipV="1">
            <a:off x="5013360" y="3676680"/>
            <a:ext cx="303120" cy="30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2" name=""/>
          <p:cNvSpPr/>
          <p:nvPr/>
        </p:nvSpPr>
        <p:spPr>
          <a:xfrm>
            <a:off x="5258520" y="360216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rcRect l="5062" t="1149" r="2564" b="0"/>
          <a:stretch/>
        </p:blipFill>
        <p:spPr>
          <a:xfrm>
            <a:off x="2039760" y="907920"/>
            <a:ext cx="5042160" cy="5042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"/>
          <p:cNvSpPr/>
          <p:nvPr/>
        </p:nvSpPr>
        <p:spPr>
          <a:xfrm>
            <a:off x="110880" y="44280"/>
            <a:ext cx="110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rmal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671120" y="29242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4773240" y="1143000"/>
            <a:ext cx="42372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>
            <a:off x="4917960" y="1143000"/>
            <a:ext cx="49536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012640" y="97308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H="1">
            <a:off x="5022360" y="1166760"/>
            <a:ext cx="830520" cy="863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796360" y="932040"/>
            <a:ext cx="965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924280" y="2398680"/>
            <a:ext cx="519120" cy="344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139920" y="1390680"/>
            <a:ext cx="360360" cy="14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396160" y="2190600"/>
            <a:ext cx="59832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AC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732760" y="1003320"/>
            <a:ext cx="5493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H="1">
            <a:off x="3557520" y="1700280"/>
            <a:ext cx="77760" cy="11779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522960" y="1420920"/>
            <a:ext cx="65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B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>
            <a:off x="5287680" y="1619280"/>
            <a:ext cx="708120" cy="1436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940360" y="144468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6100560" y="3105000"/>
            <a:ext cx="368280" cy="419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420600" y="287496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V="1">
            <a:off x="3932280" y="3061800"/>
            <a:ext cx="144360" cy="1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408480" y="299880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PON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H="1">
            <a:off x="4231800" y="2097000"/>
            <a:ext cx="11160" cy="963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128840" y="1936800"/>
            <a:ext cx="5860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795760" y="4657680"/>
            <a:ext cx="298440" cy="6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2797200" y="4847760"/>
            <a:ext cx="468360" cy="179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220120" y="455148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398840" y="4950000"/>
            <a:ext cx="409680" cy="28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851280" y="485928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H="1" flipV="1">
            <a:off x="5180040" y="5214600"/>
            <a:ext cx="171360" cy="377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164920" y="556560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H="1" flipV="1">
            <a:off x="5846400" y="5231880"/>
            <a:ext cx="237960" cy="428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012720" y="559116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H="1" flipV="1">
            <a:off x="5931000" y="5213160"/>
            <a:ext cx="249120" cy="161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6120720" y="528624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6473880" y="5223960"/>
            <a:ext cx="201600" cy="405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H="1">
            <a:off x="6234120" y="3681360"/>
            <a:ext cx="303120" cy="174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481800" y="3517920"/>
            <a:ext cx="692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H="1">
            <a:off x="6127920" y="4064040"/>
            <a:ext cx="411120" cy="49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467760" y="390204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H="1" flipV="1">
            <a:off x="6080040" y="4205160"/>
            <a:ext cx="465120" cy="152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6507360" y="4257720"/>
            <a:ext cx="583200" cy="45900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GK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086920" y="436896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2451240" y="427032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2793960" y="3244680"/>
            <a:ext cx="738360" cy="500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220840" y="36892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3932280" y="3117600"/>
            <a:ext cx="166680" cy="1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H="1" flipV="1">
            <a:off x="4368960" y="3530520"/>
            <a:ext cx="9360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373280" y="364176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H="1" flipV="1">
            <a:off x="4827240" y="4008240"/>
            <a:ext cx="11160" cy="36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060800" y="434664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flipV="1">
            <a:off x="4443480" y="3957480"/>
            <a:ext cx="30240" cy="216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4048920" y="414324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813040" y="2905200"/>
            <a:ext cx="250920" cy="266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V="1">
            <a:off x="2876400" y="3214800"/>
            <a:ext cx="235080" cy="288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390400" y="268920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228760" y="343044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935520" y="2303640"/>
            <a:ext cx="12600" cy="477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3641400" y="210492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H="1">
            <a:off x="5571720" y="2637000"/>
            <a:ext cx="871560" cy="669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6412320" y="234936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4222800" y="3738600"/>
            <a:ext cx="19080" cy="217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796560" y="392904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H="1">
            <a:off x="5843520" y="3357720"/>
            <a:ext cx="673200" cy="6015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6444720" y="325440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3059280" y="5462640"/>
            <a:ext cx="312480" cy="55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463840" y="5425920"/>
            <a:ext cx="6714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POC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065400" y="5533920"/>
            <a:ext cx="312840" cy="17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716360" y="5581800"/>
            <a:ext cx="42840" cy="288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flipH="1">
            <a:off x="4330800" y="5581800"/>
            <a:ext cx="241200" cy="263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428720" y="541656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4456080" y="1173240"/>
            <a:ext cx="547560" cy="2039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036680" y="95580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6186600" y="1822320"/>
            <a:ext cx="1008000" cy="215640"/>
          </a:xfrm>
          <a:prstGeom prst="rect">
            <a:avLst/>
          </a:prstGeom>
          <a:solidFill>
            <a:srgbClr val="f8f8f8">
              <a:alpha val="4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flipH="1">
            <a:off x="5300280" y="1916280"/>
            <a:ext cx="949320" cy="1484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348160" y="4195800"/>
            <a:ext cx="351000" cy="1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889880" y="384984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220120" y="491184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220120" y="476712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2795760" y="4807080"/>
            <a:ext cx="280800" cy="47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344760" y="4192560"/>
            <a:ext cx="25560" cy="203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flipH="1">
            <a:off x="3279600" y="4191120"/>
            <a:ext cx="20880" cy="182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H="1">
            <a:off x="3189240" y="4172040"/>
            <a:ext cx="60480" cy="177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029040" y="402732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H="1" flipV="1">
            <a:off x="5978160" y="4414320"/>
            <a:ext cx="289080" cy="33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6165000" y="4724280"/>
            <a:ext cx="10065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048560" y="510696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flipV="1">
            <a:off x="4932360" y="4521240"/>
            <a:ext cx="128520" cy="652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V="1">
            <a:off x="3995640" y="1758600"/>
            <a:ext cx="257400" cy="374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flipH="1" flipV="1">
            <a:off x="3625920" y="4176360"/>
            <a:ext cx="162000" cy="446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739320" y="454644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V="1">
            <a:off x="2860560" y="3538080"/>
            <a:ext cx="970200" cy="47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368800" y="390528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flipH="1">
            <a:off x="5130720" y="3700440"/>
            <a:ext cx="287280" cy="28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5360040" y="359568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"/>
          <p:cNvSpPr/>
          <p:nvPr/>
        </p:nvSpPr>
        <p:spPr>
          <a:xfrm>
            <a:off x="110880" y="44280"/>
            <a:ext cx="110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rmal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1" name="" descr=""/>
          <p:cNvPicPr/>
          <p:nvPr/>
        </p:nvPicPr>
        <p:blipFill>
          <a:blip r:embed="rId1"/>
          <a:srcRect l="3059" t="0" r="3900" b="0"/>
          <a:stretch/>
        </p:blipFill>
        <p:spPr>
          <a:xfrm>
            <a:off x="2050920" y="907920"/>
            <a:ext cx="5042160" cy="5042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42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671120" y="29242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flipH="1">
            <a:off x="4655880" y="1181160"/>
            <a:ext cx="42372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flipH="1">
            <a:off x="4800600" y="1181160"/>
            <a:ext cx="49536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895280" y="101124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H="1">
            <a:off x="4847760" y="1176480"/>
            <a:ext cx="830520" cy="863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5621760" y="941400"/>
            <a:ext cx="965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629080" y="2197080"/>
            <a:ext cx="563400" cy="593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2927520" y="1447920"/>
            <a:ext cx="360360" cy="14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154960" y="1989000"/>
            <a:ext cx="59832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AC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520000" y="1060560"/>
            <a:ext cx="5493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H="1">
            <a:off x="3344760" y="1757520"/>
            <a:ext cx="77760" cy="11779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310200" y="1477800"/>
            <a:ext cx="65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B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flipH="1">
            <a:off x="5138640" y="1751040"/>
            <a:ext cx="682560" cy="1271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5765760" y="155880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flipH="1">
            <a:off x="5954400" y="3067200"/>
            <a:ext cx="368280" cy="419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6274440" y="287640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flipV="1">
            <a:off x="3809880" y="3061800"/>
            <a:ext cx="144720" cy="1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3286080" y="299880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PON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flipH="1">
            <a:off x="4076280" y="2135160"/>
            <a:ext cx="11160" cy="963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954240" y="1946160"/>
            <a:ext cx="5860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620800" y="4667400"/>
            <a:ext cx="298440" cy="64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2622600" y="4857840"/>
            <a:ext cx="468360" cy="179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2045520" y="456084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4224240" y="4854600"/>
            <a:ext cx="40968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676680" y="476424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flipH="1" flipV="1">
            <a:off x="4986360" y="5100480"/>
            <a:ext cx="171360" cy="378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4980600" y="544500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flipH="1" flipV="1">
            <a:off x="5652720" y="5121360"/>
            <a:ext cx="237960" cy="428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5819040" y="547992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flipH="1" flipV="1">
            <a:off x="5727240" y="5108400"/>
            <a:ext cx="249480" cy="162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5917320" y="518148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V="1">
            <a:off x="6280200" y="5122800"/>
            <a:ext cx="306360" cy="395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flipH="1">
            <a:off x="6097680" y="3672000"/>
            <a:ext cx="303120" cy="174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6345360" y="3508200"/>
            <a:ext cx="69192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H="1">
            <a:off x="5991120" y="4016520"/>
            <a:ext cx="411120" cy="48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6331320" y="385452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flipH="1" flipV="1">
            <a:off x="5934240" y="4167000"/>
            <a:ext cx="465120" cy="152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6361560" y="4219560"/>
            <a:ext cx="583200" cy="45900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GK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017080" y="433080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flipV="1">
            <a:off x="2381400" y="423216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flipV="1">
            <a:off x="2581200" y="3273120"/>
            <a:ext cx="738360" cy="5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008080" y="369900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flipV="1">
            <a:off x="3809880" y="3117600"/>
            <a:ext cx="166680" cy="1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 flipH="1" flipV="1">
            <a:off x="4212720" y="3511440"/>
            <a:ext cx="9396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4217760" y="36226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flipH="1" flipV="1">
            <a:off x="4671720" y="3960720"/>
            <a:ext cx="11160" cy="363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3905280" y="429912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flipV="1">
            <a:off x="4287960" y="3919320"/>
            <a:ext cx="29880" cy="215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3874320" y="409572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619360" y="2971800"/>
            <a:ext cx="250920" cy="266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flipV="1">
            <a:off x="2682720" y="3281400"/>
            <a:ext cx="235080" cy="288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196720" y="275580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2035080" y="349740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3760920" y="2313000"/>
            <a:ext cx="12600" cy="477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3466800" y="211464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 flipH="1">
            <a:off x="5407200" y="2565360"/>
            <a:ext cx="871200" cy="669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6237720" y="235908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flipV="1">
            <a:off x="4067280" y="3710160"/>
            <a:ext cx="19080" cy="217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3640680" y="390060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 flipH="1">
            <a:off x="5660640" y="3392640"/>
            <a:ext cx="639720" cy="531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6270120" y="326376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flipV="1">
            <a:off x="2855880" y="5409720"/>
            <a:ext cx="312840" cy="55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2279520" y="5373720"/>
            <a:ext cx="6714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POC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2862360" y="5481720"/>
            <a:ext cx="312480" cy="17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4560840" y="5483160"/>
            <a:ext cx="42840" cy="28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flipH="1">
            <a:off x="4127040" y="5470560"/>
            <a:ext cx="241560" cy="263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4273200" y="530712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4305240" y="1312920"/>
            <a:ext cx="560520" cy="1900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3861720" y="112536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6012000" y="1832040"/>
            <a:ext cx="1008000" cy="215640"/>
          </a:xfrm>
          <a:prstGeom prst="rect">
            <a:avLst/>
          </a:prstGeom>
          <a:solidFill>
            <a:srgbClr val="f8f8f8">
              <a:alpha val="4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 flipH="1">
            <a:off x="5135040" y="1954080"/>
            <a:ext cx="946440" cy="13939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5173560" y="4138560"/>
            <a:ext cx="351000" cy="1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4715280" y="379260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2045520" y="492120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2045520" y="477684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 flipV="1">
            <a:off x="2620800" y="4816440"/>
            <a:ext cx="281160" cy="47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3151080" y="4202280"/>
            <a:ext cx="25560" cy="203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 flipH="1">
            <a:off x="3085920" y="4200480"/>
            <a:ext cx="20520" cy="182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 flipH="1">
            <a:off x="2995560" y="4181400"/>
            <a:ext cx="60480" cy="177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2835360" y="403704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 flipH="1" flipV="1">
            <a:off x="5812920" y="4328640"/>
            <a:ext cx="289080" cy="33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5999760" y="4638600"/>
            <a:ext cx="10065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883680" y="499284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 flipV="1">
            <a:off x="4767120" y="4406400"/>
            <a:ext cx="128880" cy="652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 flipV="1">
            <a:off x="3821040" y="1833480"/>
            <a:ext cx="243000" cy="309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flipH="1" flipV="1">
            <a:off x="3451320" y="4147920"/>
            <a:ext cx="162000" cy="446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3564720" y="451800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 flipV="1">
            <a:off x="2685960" y="3519000"/>
            <a:ext cx="970200" cy="47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2194200" y="391464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 flipH="1">
            <a:off x="4917960" y="3672000"/>
            <a:ext cx="287280" cy="28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5147280" y="356724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"/>
          <p:cNvSpPr/>
          <p:nvPr/>
        </p:nvSpPr>
        <p:spPr>
          <a:xfrm>
            <a:off x="110880" y="44280"/>
            <a:ext cx="110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rmal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8" name="" descr=""/>
          <p:cNvPicPr/>
          <p:nvPr/>
        </p:nvPicPr>
        <p:blipFill>
          <a:blip r:embed="rId1"/>
          <a:srcRect l="2187" t="560" r="6133" b="0"/>
          <a:stretch/>
        </p:blipFill>
        <p:spPr>
          <a:xfrm>
            <a:off x="2050920" y="907920"/>
            <a:ext cx="5042160" cy="5042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39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1671120" y="29242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 flipH="1">
            <a:off x="4725720" y="1162080"/>
            <a:ext cx="42372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 flipH="1">
            <a:off x="4870440" y="1162080"/>
            <a:ext cx="49536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4965120" y="99216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 flipH="1">
            <a:off x="4946760" y="1176480"/>
            <a:ext cx="830160" cy="863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5720400" y="941400"/>
            <a:ext cx="965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647800" y="2359080"/>
            <a:ext cx="709920" cy="422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054240" y="1428840"/>
            <a:ext cx="360360" cy="14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2291400" y="2065320"/>
            <a:ext cx="59832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AC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2647080" y="1003320"/>
            <a:ext cx="5493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flipH="1">
            <a:off x="3471840" y="1738440"/>
            <a:ext cx="77760" cy="11779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3437280" y="1459080"/>
            <a:ext cx="65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B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 flipH="1">
            <a:off x="5230800" y="1668600"/>
            <a:ext cx="396720" cy="1368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5537160" y="152100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 flipH="1">
            <a:off x="6043320" y="3075120"/>
            <a:ext cx="501480" cy="458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6487200" y="288432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 flipV="1">
            <a:off x="3957480" y="3042720"/>
            <a:ext cx="144720" cy="1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433680" y="297972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PON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 flipH="1">
            <a:off x="4222440" y="2077920"/>
            <a:ext cx="11160" cy="963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4119480" y="1917720"/>
            <a:ext cx="5860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2728800" y="4657680"/>
            <a:ext cx="298440" cy="6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 flipV="1">
            <a:off x="2730600" y="4847760"/>
            <a:ext cx="468360" cy="179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2153520" y="455148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4322880" y="4873680"/>
            <a:ext cx="40932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3774960" y="478296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 flipH="1" flipV="1">
            <a:off x="5084280" y="5094000"/>
            <a:ext cx="171720" cy="377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5069520" y="544500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 flipH="1" flipV="1">
            <a:off x="5767200" y="5148360"/>
            <a:ext cx="237960" cy="428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5933160" y="550692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 flipH="1" flipV="1">
            <a:off x="5851080" y="5129280"/>
            <a:ext cx="249480" cy="162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6041160" y="520236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 flipV="1">
            <a:off x="6394320" y="5194440"/>
            <a:ext cx="281160" cy="350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 flipH="1">
            <a:off x="6157440" y="3691080"/>
            <a:ext cx="303480" cy="174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6405480" y="3527280"/>
            <a:ext cx="692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 flipH="1">
            <a:off x="6049440" y="4022640"/>
            <a:ext cx="411480" cy="49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6390000" y="386064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 flipH="1" flipV="1">
            <a:off x="6022440" y="4168440"/>
            <a:ext cx="465480" cy="152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6450480" y="4221000"/>
            <a:ext cx="583200" cy="45900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GK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2086920" y="436896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 flipV="1">
            <a:off x="2451240" y="427032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 flipV="1">
            <a:off x="2717640" y="3263400"/>
            <a:ext cx="738360" cy="5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2144520" y="370836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 flipV="1">
            <a:off x="3957480" y="3098520"/>
            <a:ext cx="166680" cy="1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 flipH="1" flipV="1">
            <a:off x="4340160" y="3483000"/>
            <a:ext cx="9360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4344840" y="359424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 flipH="1" flipV="1">
            <a:off x="4760640" y="3922560"/>
            <a:ext cx="11160" cy="363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3994200" y="426096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 flipV="1">
            <a:off x="4395960" y="3871800"/>
            <a:ext cx="29880" cy="216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4001400" y="405756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2746440" y="2943360"/>
            <a:ext cx="250920" cy="266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 flipV="1">
            <a:off x="2809800" y="3252960"/>
            <a:ext cx="235080" cy="288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2323800" y="272736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2162160" y="346860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3895560" y="2303640"/>
            <a:ext cx="12960" cy="477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3603600" y="213372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 flipH="1">
            <a:off x="5505120" y="2617920"/>
            <a:ext cx="871560" cy="669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6345720" y="233028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 flipV="1">
            <a:off x="4184640" y="3691080"/>
            <a:ext cx="19080" cy="217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3758400" y="388152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 flipH="1">
            <a:off x="5786280" y="3338640"/>
            <a:ext cx="673200" cy="6015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6406560" y="323532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 flipV="1">
            <a:off x="2994120" y="5390640"/>
            <a:ext cx="312480" cy="55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2398680" y="5354640"/>
            <a:ext cx="6714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POC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3000240" y="5462640"/>
            <a:ext cx="312840" cy="17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4641840" y="5456160"/>
            <a:ext cx="42840" cy="28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 flipH="1">
            <a:off x="4255560" y="5456160"/>
            <a:ext cx="241560" cy="263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4354200" y="529128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4413240" y="1173240"/>
            <a:ext cx="547560" cy="2039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979440" y="96516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5651640" y="1844640"/>
            <a:ext cx="1008000" cy="215640"/>
          </a:xfrm>
          <a:prstGeom prst="rect">
            <a:avLst/>
          </a:prstGeom>
          <a:solidFill>
            <a:srgbClr val="f8f8f8">
              <a:alpha val="4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 flipH="1">
            <a:off x="5229000" y="2022480"/>
            <a:ext cx="546120" cy="1359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5262480" y="4157640"/>
            <a:ext cx="351000" cy="1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4804200" y="381168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2153520" y="491184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2153520" y="476712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 flipV="1">
            <a:off x="2728800" y="4807080"/>
            <a:ext cx="281160" cy="47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3268800" y="4192560"/>
            <a:ext cx="25200" cy="203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 flipH="1">
            <a:off x="3203280" y="4191120"/>
            <a:ext cx="20520" cy="182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H="1">
            <a:off x="3112920" y="4172040"/>
            <a:ext cx="60480" cy="177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2952720" y="402732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 flipH="1" flipV="1">
            <a:off x="5873400" y="4376880"/>
            <a:ext cx="289080" cy="334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6060240" y="4686480"/>
            <a:ext cx="10065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3969360" y="497988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 flipV="1">
            <a:off x="4853160" y="4393800"/>
            <a:ext cx="128520" cy="652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 flipV="1">
            <a:off x="3967200" y="1806120"/>
            <a:ext cx="257040" cy="374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 flipH="1" flipV="1">
            <a:off x="3578040" y="4138200"/>
            <a:ext cx="161640" cy="446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3691800" y="450864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 flipV="1">
            <a:off x="2841480" y="3481560"/>
            <a:ext cx="970200" cy="4759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2349720" y="384804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 flipH="1">
            <a:off x="5045040" y="3652920"/>
            <a:ext cx="287280" cy="28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5274360" y="354816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"/>
          <p:cNvSpPr/>
          <p:nvPr/>
        </p:nvSpPr>
        <p:spPr>
          <a:xfrm>
            <a:off x="110880" y="44280"/>
            <a:ext cx="110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rmal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5" name="" descr=""/>
          <p:cNvPicPr/>
          <p:nvPr/>
        </p:nvPicPr>
        <p:blipFill>
          <a:blip r:embed="rId1"/>
          <a:srcRect l="3076" t="1078" r="5699" b="0"/>
          <a:stretch/>
        </p:blipFill>
        <p:spPr>
          <a:xfrm>
            <a:off x="2050920" y="907920"/>
            <a:ext cx="5042160" cy="5042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36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1680480" y="293364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 flipH="1">
            <a:off x="4716360" y="1200240"/>
            <a:ext cx="42408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 flipH="1">
            <a:off x="4860720" y="1200240"/>
            <a:ext cx="49500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4955760" y="103032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 flipH="1">
            <a:off x="4917600" y="1195560"/>
            <a:ext cx="830520" cy="863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5691600" y="1008000"/>
            <a:ext cx="965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2819520" y="2379600"/>
            <a:ext cx="519120" cy="344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3035160" y="1371600"/>
            <a:ext cx="360360" cy="14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2291400" y="2171880"/>
            <a:ext cx="59832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AC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2608920" y="1041480"/>
            <a:ext cx="5493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 flipH="1">
            <a:off x="3462480" y="1484280"/>
            <a:ext cx="101520" cy="1346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3319920" y="1192320"/>
            <a:ext cx="65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B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 flipH="1">
            <a:off x="5221440" y="1774800"/>
            <a:ext cx="512640" cy="1319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5651640" y="162072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 flipH="1">
            <a:off x="6043320" y="3027240"/>
            <a:ext cx="493560" cy="516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6516000" y="2852640"/>
            <a:ext cx="560160" cy="33732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 flipV="1">
            <a:off x="3932280" y="3014640"/>
            <a:ext cx="144360" cy="1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3408480" y="295128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PON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 flipH="1">
            <a:off x="4193640" y="2077920"/>
            <a:ext cx="11160" cy="963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4081320" y="1917720"/>
            <a:ext cx="5860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2738520" y="4648320"/>
            <a:ext cx="298440" cy="64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 flipV="1">
            <a:off x="2739960" y="4838760"/>
            <a:ext cx="468360" cy="179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2162880" y="454176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4329000" y="4878360"/>
            <a:ext cx="40968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3781440" y="478800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 flipH="1" flipV="1">
            <a:off x="5054760" y="5113080"/>
            <a:ext cx="171360" cy="377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5039640" y="546408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 flipH="1" flipV="1">
            <a:off x="5795640" y="5186520"/>
            <a:ext cx="237960" cy="428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5961960" y="554508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 flipH="1" flipV="1">
            <a:off x="5880240" y="5167080"/>
            <a:ext cx="249120" cy="161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6069600" y="524016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 flipV="1">
            <a:off x="6423120" y="5178600"/>
            <a:ext cx="201600" cy="404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 flipH="1">
            <a:off x="6157440" y="3719520"/>
            <a:ext cx="303480" cy="174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6405480" y="3556080"/>
            <a:ext cx="692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 flipH="1">
            <a:off x="6080040" y="4073400"/>
            <a:ext cx="411120" cy="49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6420240" y="391176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 flipH="1" flipV="1">
            <a:off x="6041880" y="4243320"/>
            <a:ext cx="465120" cy="152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6469560" y="4295880"/>
            <a:ext cx="583200" cy="45900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GK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2086920" y="436896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 flipV="1">
            <a:off x="2451240" y="427032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 flipV="1">
            <a:off x="2717640" y="3234960"/>
            <a:ext cx="738360" cy="5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2144520" y="367992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 flipV="1">
            <a:off x="3922560" y="3079440"/>
            <a:ext cx="166680" cy="1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 flipH="1" flipV="1">
            <a:off x="4340160" y="3463920"/>
            <a:ext cx="9360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4344840" y="357516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 flipH="1" flipV="1">
            <a:off x="4760640" y="3960720"/>
            <a:ext cx="11160" cy="363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3994200" y="429912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 flipV="1">
            <a:off x="4405320" y="3879720"/>
            <a:ext cx="30240" cy="216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4010760" y="406548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2746440" y="2952720"/>
            <a:ext cx="250920" cy="266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 flipV="1">
            <a:off x="2809800" y="3261960"/>
            <a:ext cx="235080" cy="28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2323800" y="273672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2162160" y="347832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3887640" y="2287440"/>
            <a:ext cx="12960" cy="478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3593880" y="209556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 flipH="1">
            <a:off x="5486040" y="2637000"/>
            <a:ext cx="871560" cy="669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6326640" y="234936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 flipV="1">
            <a:off x="4194000" y="3672000"/>
            <a:ext cx="19080" cy="217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3767760" y="386244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 flipH="1">
            <a:off x="5786280" y="3386160"/>
            <a:ext cx="673200" cy="6015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6397200" y="327348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 flipV="1">
            <a:off x="3008160" y="5405400"/>
            <a:ext cx="312840" cy="55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2413080" y="5369040"/>
            <a:ext cx="6714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POC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3014640" y="5477040"/>
            <a:ext cx="312840" cy="17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4659480" y="5448240"/>
            <a:ext cx="42840" cy="28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 flipH="1">
            <a:off x="4273560" y="5448240"/>
            <a:ext cx="241200" cy="263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4371480" y="528336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4389480" y="1220760"/>
            <a:ext cx="547560" cy="2040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3960360" y="101268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5867280" y="1916280"/>
            <a:ext cx="690840" cy="337320"/>
          </a:xfrm>
          <a:prstGeom prst="rect">
            <a:avLst/>
          </a:prstGeom>
          <a:solidFill>
            <a:srgbClr val="f8f8f8">
              <a:alpha val="4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 flipH="1">
            <a:off x="5243400" y="2205000"/>
            <a:ext cx="696960" cy="1185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5284800" y="4176720"/>
            <a:ext cx="351000" cy="1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4826520" y="383076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2162880" y="490212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2162880" y="475776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 flipV="1">
            <a:off x="2738520" y="4797360"/>
            <a:ext cx="280800" cy="47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3278160" y="4192560"/>
            <a:ext cx="25560" cy="203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 flipH="1">
            <a:off x="3213000" y="4191120"/>
            <a:ext cx="20880" cy="182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 flipH="1">
            <a:off x="3122280" y="4172040"/>
            <a:ext cx="60120" cy="177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2962440" y="402732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 flipH="1" flipV="1">
            <a:off x="5897160" y="4414320"/>
            <a:ext cx="289080" cy="33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6084000" y="4724280"/>
            <a:ext cx="10065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3978720" y="495612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 flipV="1">
            <a:off x="4859280" y="4436640"/>
            <a:ext cx="122400" cy="576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 flipV="1">
            <a:off x="3948120" y="1806480"/>
            <a:ext cx="257040" cy="300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 flipH="1" flipV="1">
            <a:off x="3606840" y="4109760"/>
            <a:ext cx="162000" cy="446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3720600" y="447984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 flipV="1">
            <a:off x="2852640" y="3447720"/>
            <a:ext cx="970200" cy="47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2368800" y="383868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 flipH="1">
            <a:off x="5035680" y="3728880"/>
            <a:ext cx="287280" cy="28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5265000" y="362412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1" name=""/>
          <p:cNvSpPr/>
          <p:nvPr/>
        </p:nvSpPr>
        <p:spPr>
          <a:xfrm>
            <a:off x="110880" y="44280"/>
            <a:ext cx="110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rmal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2" name="" descr=""/>
          <p:cNvPicPr/>
          <p:nvPr/>
        </p:nvPicPr>
        <p:blipFill>
          <a:blip r:embed="rId1"/>
          <a:srcRect l="2853" t="829" r="5314" b="0"/>
          <a:stretch/>
        </p:blipFill>
        <p:spPr>
          <a:xfrm>
            <a:off x="2050920" y="896760"/>
            <a:ext cx="5042160" cy="5053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3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1594800" y="300024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 flipH="1">
            <a:off x="4678200" y="1133640"/>
            <a:ext cx="42408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 flipH="1">
            <a:off x="4822920" y="1133640"/>
            <a:ext cx="49536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4917600" y="96372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 flipH="1">
            <a:off x="4908600" y="1157400"/>
            <a:ext cx="830160" cy="863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5682240" y="922320"/>
            <a:ext cx="965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2800440" y="2398680"/>
            <a:ext cx="519120" cy="344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3016080" y="1390680"/>
            <a:ext cx="360360" cy="14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2272320" y="2190600"/>
            <a:ext cx="59832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AC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2608920" y="1003320"/>
            <a:ext cx="5493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 flipH="1">
            <a:off x="3433680" y="1690560"/>
            <a:ext cx="77760" cy="11779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3399120" y="1411200"/>
            <a:ext cx="65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FETU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B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 flipH="1">
            <a:off x="5202360" y="1619280"/>
            <a:ext cx="707760" cy="1436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5854680" y="152100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 flipH="1">
            <a:off x="6043320" y="3052800"/>
            <a:ext cx="452520" cy="450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6449040" y="2874960"/>
            <a:ext cx="560160" cy="33732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 flipV="1">
            <a:off x="3903840" y="3071880"/>
            <a:ext cx="144360" cy="1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3379680" y="300816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PON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 flipH="1">
            <a:off x="4203360" y="2122560"/>
            <a:ext cx="3240" cy="909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4090680" y="1965240"/>
            <a:ext cx="5860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2700360" y="4727520"/>
            <a:ext cx="298440" cy="6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 flipV="1">
            <a:off x="2701800" y="4917600"/>
            <a:ext cx="468360" cy="179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2124720" y="462132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4313160" y="4911840"/>
            <a:ext cx="40968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3765240" y="482112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 flipH="1" flipV="1">
            <a:off x="5057280" y="5084640"/>
            <a:ext cx="171720" cy="378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5177520" y="539748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 flipH="1" flipV="1">
            <a:off x="5743440" y="5167440"/>
            <a:ext cx="238320" cy="428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5909400" y="552600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 flipH="1" flipV="1">
            <a:off x="5827680" y="5148360"/>
            <a:ext cx="249120" cy="162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6017400" y="522144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 flipV="1">
            <a:off x="6370560" y="5203440"/>
            <a:ext cx="263520" cy="360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 flipH="1">
            <a:off x="6156360" y="3700440"/>
            <a:ext cx="303120" cy="174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6424560" y="3517920"/>
            <a:ext cx="692280" cy="33732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 flipH="1">
            <a:off x="6060960" y="4064040"/>
            <a:ext cx="411120" cy="49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6401160" y="390204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 flipH="1" flipV="1">
            <a:off x="6004080" y="4205160"/>
            <a:ext cx="465120" cy="152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6431400" y="4257720"/>
            <a:ext cx="583200" cy="45900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GK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2067840" y="440676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 flipV="1">
            <a:off x="2432160" y="430848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 flipV="1">
            <a:off x="2698920" y="3273120"/>
            <a:ext cx="738000" cy="5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2125440" y="37180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 flipV="1">
            <a:off x="3903840" y="3126960"/>
            <a:ext cx="166680" cy="1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 flipH="1" flipV="1">
            <a:off x="4321080" y="3502080"/>
            <a:ext cx="9360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4325760" y="361332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 flipH="1" flipV="1">
            <a:off x="4741560" y="3989160"/>
            <a:ext cx="11160" cy="36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3975120" y="432756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 flipV="1">
            <a:off x="4386240" y="3929040"/>
            <a:ext cx="30240" cy="216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3991680" y="411480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2736720" y="3019320"/>
            <a:ext cx="250920" cy="266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 flipV="1">
            <a:off x="2800440" y="3328560"/>
            <a:ext cx="234720" cy="28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2314080" y="280368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2152440" y="354492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 flipH="1">
            <a:off x="3862440" y="2254320"/>
            <a:ext cx="25200" cy="546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3612960" y="209556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 flipH="1">
            <a:off x="5466960" y="2627280"/>
            <a:ext cx="871560" cy="669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6307560" y="234000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 flipV="1">
            <a:off x="4165560" y="3738600"/>
            <a:ext cx="19080" cy="217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3739320" y="3929040"/>
            <a:ext cx="5983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 flipH="1">
            <a:off x="5748120" y="3357720"/>
            <a:ext cx="672840" cy="6015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6373440" y="324468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 flipV="1">
            <a:off x="2970360" y="5490720"/>
            <a:ext cx="312480" cy="55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2374920" y="5454720"/>
            <a:ext cx="6714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APOC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2976480" y="5562720"/>
            <a:ext cx="312840" cy="17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4630680" y="5533920"/>
            <a:ext cx="42840" cy="28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 flipH="1">
            <a:off x="4245120" y="5533920"/>
            <a:ext cx="241200" cy="263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4343040" y="536904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4389480" y="1201680"/>
            <a:ext cx="547560" cy="2040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3969720" y="98424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6103800" y="1822320"/>
            <a:ext cx="1008360" cy="215640"/>
          </a:xfrm>
          <a:prstGeom prst="rect">
            <a:avLst/>
          </a:prstGeom>
          <a:solidFill>
            <a:srgbClr val="f8f8f8">
              <a:alpha val="4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 flipH="1">
            <a:off x="5209920" y="1935000"/>
            <a:ext cx="949320" cy="1484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5243400" y="4176720"/>
            <a:ext cx="351000" cy="1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4785120" y="383076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2124720" y="498168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2124720" y="483696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 flipV="1">
            <a:off x="2700360" y="4876920"/>
            <a:ext cx="280800" cy="47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3249720" y="4268880"/>
            <a:ext cx="25200" cy="203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 flipH="1">
            <a:off x="3184200" y="4267080"/>
            <a:ext cx="20520" cy="182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 flipH="1">
            <a:off x="3093840" y="4248000"/>
            <a:ext cx="60120" cy="177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2971800" y="409716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 flipH="1" flipV="1">
            <a:off x="5881320" y="4424400"/>
            <a:ext cx="289080" cy="334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5990040" y="4724280"/>
            <a:ext cx="1006560" cy="45900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4029480" y="503244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 flipV="1">
            <a:off x="4840200" y="4435560"/>
            <a:ext cx="128520" cy="652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 flipV="1">
            <a:off x="3924360" y="1825560"/>
            <a:ext cx="271440" cy="308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 flipH="1" flipV="1">
            <a:off x="3568680" y="4167000"/>
            <a:ext cx="162000" cy="446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3682440" y="453708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 flipV="1">
            <a:off x="2832120" y="3499920"/>
            <a:ext cx="969840" cy="47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2340000" y="386712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 flipH="1" flipV="1">
            <a:off x="5025960" y="3700080"/>
            <a:ext cx="223920" cy="73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5169600" y="368136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8" name=""/>
          <p:cNvSpPr/>
          <p:nvPr/>
        </p:nvSpPr>
        <p:spPr>
          <a:xfrm>
            <a:off x="110880" y="4428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irrhosis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9" name="" descr=""/>
          <p:cNvPicPr/>
          <p:nvPr/>
        </p:nvPicPr>
        <p:blipFill>
          <a:blip r:embed="rId1"/>
          <a:srcRect l="6282" t="1939" r="2651" b="0"/>
          <a:stretch/>
        </p:blipFill>
        <p:spPr>
          <a:xfrm>
            <a:off x="2050920" y="896760"/>
            <a:ext cx="5042160" cy="5053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30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>
            <a:off x="1671120" y="29242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 flipH="1">
            <a:off x="4722480" y="1165320"/>
            <a:ext cx="42372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 flipH="1">
            <a:off x="4867200" y="1165320"/>
            <a:ext cx="49536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4944600" y="98100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 flipH="1">
            <a:off x="4893840" y="1198440"/>
            <a:ext cx="787320" cy="8622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5626800" y="932040"/>
            <a:ext cx="965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 flipH="1">
            <a:off x="5224320" y="1413000"/>
            <a:ext cx="789120" cy="164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5932440" y="127008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 flipH="1">
            <a:off x="6068880" y="3052800"/>
            <a:ext cx="547920" cy="442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6584040" y="290520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2724120" y="4816440"/>
            <a:ext cx="298440" cy="6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 flipV="1">
            <a:off x="2735280" y="4997520"/>
            <a:ext cx="468360" cy="179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>
            <a:off x="2148480" y="471024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4309920" y="4951440"/>
            <a:ext cx="40968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3762360" y="486108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 flipV="1">
            <a:off x="4862520" y="5200560"/>
            <a:ext cx="214200" cy="426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"/>
          <p:cNvSpPr/>
          <p:nvPr/>
        </p:nvSpPr>
        <p:spPr>
          <a:xfrm>
            <a:off x="4572720" y="561348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"/>
          <p:cNvSpPr/>
          <p:nvPr/>
        </p:nvSpPr>
        <p:spPr>
          <a:xfrm flipH="1" flipV="1">
            <a:off x="5795640" y="5229000"/>
            <a:ext cx="253800" cy="31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"/>
          <p:cNvSpPr/>
          <p:nvPr/>
        </p:nvSpPr>
        <p:spPr>
          <a:xfrm>
            <a:off x="5979240" y="547380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 flipV="1">
            <a:off x="6456240" y="5186520"/>
            <a:ext cx="201600" cy="404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 flipH="1">
            <a:off x="6165360" y="3706920"/>
            <a:ext cx="303480" cy="174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6410160" y="3524400"/>
            <a:ext cx="692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 flipH="1">
            <a:off x="6078240" y="4014720"/>
            <a:ext cx="422280" cy="109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6469560" y="388476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2042640" y="449568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 flipV="1">
            <a:off x="2406600" y="439740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 flipV="1">
            <a:off x="2693880" y="3265200"/>
            <a:ext cx="738360" cy="5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2128680" y="36910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 flipH="1" flipV="1">
            <a:off x="4334040" y="3519360"/>
            <a:ext cx="9360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4282920" y="363852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 flipH="1" flipV="1">
            <a:off x="4752720" y="4014360"/>
            <a:ext cx="11160" cy="389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3978360" y="435780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 flipV="1">
            <a:off x="4303800" y="3895200"/>
            <a:ext cx="133200" cy="297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3928320" y="414504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2627280" y="2927520"/>
            <a:ext cx="250920" cy="266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 flipV="1">
            <a:off x="2690640" y="3236400"/>
            <a:ext cx="235080" cy="28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2204640" y="271152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>
            <a:off x="2043000" y="345276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3851280" y="2313000"/>
            <a:ext cx="4680" cy="534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3512880" y="213516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 flipH="1">
            <a:off x="5472000" y="2521080"/>
            <a:ext cx="952560" cy="782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6367680" y="239400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 flipH="1">
            <a:off x="5795640" y="3411360"/>
            <a:ext cx="693720" cy="551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6441480" y="328464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3768840" y="1170000"/>
            <a:ext cx="250560" cy="593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3344400" y="946080"/>
            <a:ext cx="56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TIH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 flipH="1">
            <a:off x="5770080" y="2190600"/>
            <a:ext cx="530280" cy="622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6227640" y="2027160"/>
            <a:ext cx="936720" cy="33732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V304,HV30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4394160" y="1216080"/>
            <a:ext cx="547560" cy="2039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3982680" y="103176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 flipH="1">
            <a:off x="5195880" y="1662120"/>
            <a:ext cx="874800" cy="16365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6000480" y="1504800"/>
            <a:ext cx="586080" cy="21564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>
            <a:off x="2725560" y="5373720"/>
            <a:ext cx="21132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>
            <a:off x="2395080" y="526896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>
            <a:off x="6066000" y="1765440"/>
            <a:ext cx="100800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 flipH="1">
            <a:off x="5223960" y="1905120"/>
            <a:ext cx="909720" cy="15094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 flipV="1">
            <a:off x="5332320" y="4193640"/>
            <a:ext cx="298440" cy="162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4845600" y="386244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 flipH="1" flipV="1">
            <a:off x="5428800" y="5238360"/>
            <a:ext cx="73080" cy="235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5214960" y="544500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2158200" y="506088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2158200" y="491652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 flipV="1">
            <a:off x="2733840" y="4956120"/>
            <a:ext cx="280800" cy="47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3281400" y="5105520"/>
            <a:ext cx="4856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 flipH="1" flipV="1">
            <a:off x="3317400" y="4896000"/>
            <a:ext cx="73080" cy="249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 flipH="1" flipV="1">
            <a:off x="3433320" y="4579560"/>
            <a:ext cx="50760" cy="544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3271680" y="4327560"/>
            <a:ext cx="51120" cy="195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 flipH="1">
            <a:off x="3206520" y="4325760"/>
            <a:ext cx="20520" cy="1828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 flipH="1">
            <a:off x="3116160" y="4307040"/>
            <a:ext cx="60480" cy="1774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2955960" y="416232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 flipH="1" flipV="1">
            <a:off x="5925960" y="4457520"/>
            <a:ext cx="324000" cy="166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6018840" y="4591080"/>
            <a:ext cx="10065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3970800" y="508464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 flipV="1">
            <a:off x="4854600" y="4498560"/>
            <a:ext cx="128520" cy="652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 flipV="1">
            <a:off x="3871800" y="1809360"/>
            <a:ext cx="322200" cy="352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 flipH="1" flipV="1">
            <a:off x="3565440" y="4221000"/>
            <a:ext cx="162000" cy="446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3571200" y="462456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 flipV="1">
            <a:off x="2833560" y="3538080"/>
            <a:ext cx="970200" cy="47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2345040" y="393552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 flipV="1">
            <a:off x="3638520" y="3625920"/>
            <a:ext cx="476280" cy="234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3357720" y="3828960"/>
            <a:ext cx="529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 flipH="1">
            <a:off x="5048280" y="3697200"/>
            <a:ext cx="287280" cy="28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"/>
          <p:cNvSpPr/>
          <p:nvPr/>
        </p:nvSpPr>
        <p:spPr>
          <a:xfrm>
            <a:off x="5277600" y="359244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7" name=""/>
          <p:cNvSpPr/>
          <p:nvPr/>
        </p:nvSpPr>
        <p:spPr>
          <a:xfrm>
            <a:off x="110880" y="4428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irrhosis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8" name="" descr=""/>
          <p:cNvPicPr/>
          <p:nvPr/>
        </p:nvPicPr>
        <p:blipFill>
          <a:blip r:embed="rId1"/>
          <a:srcRect l="4135" t="1418" r="4135" b="0"/>
          <a:stretch/>
        </p:blipFill>
        <p:spPr>
          <a:xfrm>
            <a:off x="2050920" y="907920"/>
            <a:ext cx="5042160" cy="5042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19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>
            <a:off x="1671120" y="29242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 flipH="1">
            <a:off x="4646520" y="1127160"/>
            <a:ext cx="42408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 flipH="1">
            <a:off x="4790880" y="1127160"/>
            <a:ext cx="495000" cy="585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4868280" y="94284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 flipH="1">
            <a:off x="4893840" y="1125360"/>
            <a:ext cx="787320" cy="8622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>
            <a:off x="5626800" y="932040"/>
            <a:ext cx="965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 flipH="1">
            <a:off x="5214960" y="1500120"/>
            <a:ext cx="566640" cy="15778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5651640" y="134316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 flipH="1">
            <a:off x="6011640" y="3081240"/>
            <a:ext cx="547560" cy="443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6526800" y="293364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2665440" y="4740120"/>
            <a:ext cx="298440" cy="6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 flipV="1">
            <a:off x="2676600" y="4921200"/>
            <a:ext cx="468360" cy="179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2089800" y="463392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4281480" y="4894200"/>
            <a:ext cx="40968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>
            <a:off x="3733560" y="480384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 flipV="1">
            <a:off x="4862520" y="5200560"/>
            <a:ext cx="214200" cy="426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4501440" y="561348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 flipH="1" flipV="1">
            <a:off x="5676480" y="5229000"/>
            <a:ext cx="235080" cy="42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>
            <a:off x="5860440" y="558180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 flipV="1">
            <a:off x="6345360" y="5186520"/>
            <a:ext cx="193680" cy="4759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 flipH="1">
            <a:off x="6127560" y="3706920"/>
            <a:ext cx="393480" cy="144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6477120" y="3543480"/>
            <a:ext cx="69192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 flipH="1" flipV="1">
            <a:off x="6040080" y="4105080"/>
            <a:ext cx="485640" cy="21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>
            <a:off x="6469560" y="402912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2042640" y="441000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 flipV="1">
            <a:off x="2406600" y="431172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 flipV="1">
            <a:off x="2665440" y="3303360"/>
            <a:ext cx="738000" cy="5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2100240" y="37288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 flipH="1" flipV="1">
            <a:off x="4295880" y="3490920"/>
            <a:ext cx="9360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>
            <a:off x="4244760" y="36100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 flipH="1" flipV="1">
            <a:off x="4714560" y="3976200"/>
            <a:ext cx="11160" cy="389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3940200" y="431964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 flipV="1">
            <a:off x="4255920" y="3895200"/>
            <a:ext cx="133560" cy="297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"/>
          <p:cNvSpPr/>
          <p:nvPr/>
        </p:nvSpPr>
        <p:spPr>
          <a:xfrm>
            <a:off x="3880440" y="414504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"/>
          <p:cNvSpPr/>
          <p:nvPr/>
        </p:nvSpPr>
        <p:spPr>
          <a:xfrm>
            <a:off x="2627280" y="2927520"/>
            <a:ext cx="250920" cy="2664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"/>
          <p:cNvSpPr/>
          <p:nvPr/>
        </p:nvSpPr>
        <p:spPr>
          <a:xfrm flipV="1">
            <a:off x="2690640" y="3236400"/>
            <a:ext cx="235080" cy="289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2204640" y="271152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2043000" y="345276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>
            <a:off x="3851280" y="2274840"/>
            <a:ext cx="4680" cy="534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>
            <a:off x="3512880" y="211608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"/>
          <p:cNvSpPr/>
          <p:nvPr/>
        </p:nvSpPr>
        <p:spPr>
          <a:xfrm flipH="1">
            <a:off x="5443560" y="2549520"/>
            <a:ext cx="952560" cy="782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"/>
          <p:cNvSpPr/>
          <p:nvPr/>
        </p:nvSpPr>
        <p:spPr>
          <a:xfrm>
            <a:off x="6339240" y="241308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"/>
          <p:cNvSpPr/>
          <p:nvPr/>
        </p:nvSpPr>
        <p:spPr>
          <a:xfrm flipH="1">
            <a:off x="5724360" y="3382920"/>
            <a:ext cx="765360" cy="522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"/>
          <p:cNvSpPr/>
          <p:nvPr/>
        </p:nvSpPr>
        <p:spPr>
          <a:xfrm>
            <a:off x="6441480" y="328464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"/>
          <p:cNvSpPr/>
          <p:nvPr/>
        </p:nvSpPr>
        <p:spPr>
          <a:xfrm>
            <a:off x="3759120" y="1150920"/>
            <a:ext cx="250920" cy="593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"/>
          <p:cNvSpPr/>
          <p:nvPr/>
        </p:nvSpPr>
        <p:spPr>
          <a:xfrm>
            <a:off x="3334680" y="927000"/>
            <a:ext cx="56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TIH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"/>
          <p:cNvSpPr/>
          <p:nvPr/>
        </p:nvSpPr>
        <p:spPr>
          <a:xfrm flipH="1">
            <a:off x="5714640" y="2133720"/>
            <a:ext cx="585720" cy="612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"/>
          <p:cNvSpPr/>
          <p:nvPr/>
        </p:nvSpPr>
        <p:spPr>
          <a:xfrm>
            <a:off x="6227640" y="2027160"/>
            <a:ext cx="936720" cy="33732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V304,HV30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"/>
          <p:cNvSpPr/>
          <p:nvPr/>
        </p:nvSpPr>
        <p:spPr>
          <a:xfrm>
            <a:off x="4365720" y="1154160"/>
            <a:ext cx="547560" cy="2039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"/>
          <p:cNvSpPr/>
          <p:nvPr/>
        </p:nvSpPr>
        <p:spPr>
          <a:xfrm>
            <a:off x="3953880" y="98424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"/>
          <p:cNvSpPr/>
          <p:nvPr/>
        </p:nvSpPr>
        <p:spPr>
          <a:xfrm flipH="1">
            <a:off x="5205240" y="1662120"/>
            <a:ext cx="874800" cy="16365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"/>
          <p:cNvSpPr/>
          <p:nvPr/>
        </p:nvSpPr>
        <p:spPr>
          <a:xfrm>
            <a:off x="6019560" y="1542960"/>
            <a:ext cx="586080" cy="21564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"/>
          <p:cNvSpPr/>
          <p:nvPr/>
        </p:nvSpPr>
        <p:spPr>
          <a:xfrm>
            <a:off x="2657520" y="5288040"/>
            <a:ext cx="21096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"/>
          <p:cNvSpPr/>
          <p:nvPr/>
        </p:nvSpPr>
        <p:spPr>
          <a:xfrm>
            <a:off x="2327040" y="518328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"/>
          <p:cNvSpPr/>
          <p:nvPr/>
        </p:nvSpPr>
        <p:spPr>
          <a:xfrm>
            <a:off x="6046920" y="1793880"/>
            <a:ext cx="100800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"/>
          <p:cNvSpPr/>
          <p:nvPr/>
        </p:nvSpPr>
        <p:spPr>
          <a:xfrm flipH="1">
            <a:off x="5204880" y="1933560"/>
            <a:ext cx="909720" cy="1509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"/>
          <p:cNvSpPr/>
          <p:nvPr/>
        </p:nvSpPr>
        <p:spPr>
          <a:xfrm flipV="1">
            <a:off x="5294160" y="4212720"/>
            <a:ext cx="298440" cy="162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"/>
          <p:cNvSpPr/>
          <p:nvPr/>
        </p:nvSpPr>
        <p:spPr>
          <a:xfrm>
            <a:off x="4807440" y="388152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"/>
          <p:cNvSpPr/>
          <p:nvPr/>
        </p:nvSpPr>
        <p:spPr>
          <a:xfrm flipH="1" flipV="1">
            <a:off x="5409720" y="5243040"/>
            <a:ext cx="73080" cy="235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"/>
          <p:cNvSpPr/>
          <p:nvPr/>
        </p:nvSpPr>
        <p:spPr>
          <a:xfrm>
            <a:off x="5195880" y="545004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"/>
          <p:cNvSpPr/>
          <p:nvPr/>
        </p:nvSpPr>
        <p:spPr>
          <a:xfrm>
            <a:off x="2099520" y="498492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"/>
          <p:cNvSpPr/>
          <p:nvPr/>
        </p:nvSpPr>
        <p:spPr>
          <a:xfrm>
            <a:off x="2099520" y="484020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"/>
          <p:cNvSpPr/>
          <p:nvPr/>
        </p:nvSpPr>
        <p:spPr>
          <a:xfrm flipV="1">
            <a:off x="2674800" y="4879440"/>
            <a:ext cx="281160" cy="478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"/>
          <p:cNvSpPr/>
          <p:nvPr/>
        </p:nvSpPr>
        <p:spPr>
          <a:xfrm>
            <a:off x="3271680" y="5000760"/>
            <a:ext cx="4856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"/>
          <p:cNvSpPr/>
          <p:nvPr/>
        </p:nvSpPr>
        <p:spPr>
          <a:xfrm flipH="1" flipV="1">
            <a:off x="3308040" y="4791240"/>
            <a:ext cx="73080" cy="249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"/>
          <p:cNvSpPr/>
          <p:nvPr/>
        </p:nvSpPr>
        <p:spPr>
          <a:xfrm flipH="1" flipV="1">
            <a:off x="3423960" y="4474800"/>
            <a:ext cx="50760" cy="544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"/>
          <p:cNvSpPr/>
          <p:nvPr/>
        </p:nvSpPr>
        <p:spPr>
          <a:xfrm>
            <a:off x="3224160" y="4280040"/>
            <a:ext cx="50760" cy="195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"/>
          <p:cNvSpPr/>
          <p:nvPr/>
        </p:nvSpPr>
        <p:spPr>
          <a:xfrm flipH="1">
            <a:off x="3159000" y="4278240"/>
            <a:ext cx="20880" cy="182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"/>
          <p:cNvSpPr/>
          <p:nvPr/>
        </p:nvSpPr>
        <p:spPr>
          <a:xfrm flipH="1">
            <a:off x="3068640" y="4259160"/>
            <a:ext cx="60480" cy="177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"/>
          <p:cNvSpPr/>
          <p:nvPr/>
        </p:nvSpPr>
        <p:spPr>
          <a:xfrm>
            <a:off x="2908440" y="411480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"/>
          <p:cNvSpPr/>
          <p:nvPr/>
        </p:nvSpPr>
        <p:spPr>
          <a:xfrm flipH="1" flipV="1">
            <a:off x="5878440" y="4438800"/>
            <a:ext cx="277920" cy="3585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"/>
          <p:cNvSpPr/>
          <p:nvPr/>
        </p:nvSpPr>
        <p:spPr>
          <a:xfrm>
            <a:off x="6103080" y="4619520"/>
            <a:ext cx="10065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"/>
          <p:cNvSpPr/>
          <p:nvPr/>
        </p:nvSpPr>
        <p:spPr>
          <a:xfrm>
            <a:off x="3942360" y="505620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"/>
          <p:cNvSpPr/>
          <p:nvPr/>
        </p:nvSpPr>
        <p:spPr>
          <a:xfrm flipV="1">
            <a:off x="4826160" y="4470480"/>
            <a:ext cx="128520" cy="652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"/>
          <p:cNvSpPr/>
          <p:nvPr/>
        </p:nvSpPr>
        <p:spPr>
          <a:xfrm flipV="1">
            <a:off x="3852720" y="1790280"/>
            <a:ext cx="322560" cy="352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"/>
          <p:cNvSpPr/>
          <p:nvPr/>
        </p:nvSpPr>
        <p:spPr>
          <a:xfrm flipH="1" flipV="1">
            <a:off x="3546360" y="4317480"/>
            <a:ext cx="138240" cy="319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"/>
          <p:cNvSpPr/>
          <p:nvPr/>
        </p:nvSpPr>
        <p:spPr>
          <a:xfrm>
            <a:off x="3618720" y="454824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"/>
          <p:cNvSpPr/>
          <p:nvPr/>
        </p:nvSpPr>
        <p:spPr>
          <a:xfrm flipV="1">
            <a:off x="2805120" y="3509640"/>
            <a:ext cx="969840" cy="47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"/>
          <p:cNvSpPr/>
          <p:nvPr/>
        </p:nvSpPr>
        <p:spPr>
          <a:xfrm>
            <a:off x="2316240" y="390672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"/>
          <p:cNvSpPr/>
          <p:nvPr/>
        </p:nvSpPr>
        <p:spPr>
          <a:xfrm flipV="1">
            <a:off x="3708360" y="3578400"/>
            <a:ext cx="397080" cy="282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"/>
          <p:cNvSpPr/>
          <p:nvPr/>
        </p:nvSpPr>
        <p:spPr>
          <a:xfrm>
            <a:off x="3357720" y="3828960"/>
            <a:ext cx="529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"/>
          <p:cNvSpPr/>
          <p:nvPr/>
        </p:nvSpPr>
        <p:spPr>
          <a:xfrm flipH="1" flipV="1">
            <a:off x="5029200" y="3673080"/>
            <a:ext cx="263520" cy="42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"/>
          <p:cNvSpPr/>
          <p:nvPr/>
        </p:nvSpPr>
        <p:spPr>
          <a:xfrm>
            <a:off x="5230080" y="363708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6" name=""/>
          <p:cNvSpPr/>
          <p:nvPr/>
        </p:nvSpPr>
        <p:spPr>
          <a:xfrm>
            <a:off x="110880" y="4428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irrhosis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7" name="" descr=""/>
          <p:cNvPicPr/>
          <p:nvPr/>
        </p:nvPicPr>
        <p:blipFill>
          <a:blip r:embed="rId1"/>
          <a:srcRect l="3570" t="1388" r="5242" b="0"/>
          <a:stretch/>
        </p:blipFill>
        <p:spPr>
          <a:xfrm>
            <a:off x="2050920" y="907920"/>
            <a:ext cx="5042160" cy="5042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08" name=""/>
          <p:cNvSpPr/>
          <p:nvPr/>
        </p:nvSpPr>
        <p:spPr>
          <a:xfrm>
            <a:off x="1506960" y="455760"/>
            <a:ext cx="61668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GB" sz="14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kD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"/>
          <p:cNvSpPr/>
          <p:nvPr/>
        </p:nvSpPr>
        <p:spPr>
          <a:xfrm>
            <a:off x="1553040" y="9079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"/>
          <p:cNvSpPr/>
          <p:nvPr/>
        </p:nvSpPr>
        <p:spPr>
          <a:xfrm>
            <a:off x="1648800" y="5645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"/>
          <p:cNvSpPr/>
          <p:nvPr/>
        </p:nvSpPr>
        <p:spPr>
          <a:xfrm>
            <a:off x="1671120" y="29242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"/>
          <p:cNvSpPr/>
          <p:nvPr/>
        </p:nvSpPr>
        <p:spPr>
          <a:xfrm>
            <a:off x="1690560" y="5952960"/>
            <a:ext cx="553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 3                                                                                              5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"/>
          <p:cNvSpPr/>
          <p:nvPr/>
        </p:nvSpPr>
        <p:spPr>
          <a:xfrm flipH="1">
            <a:off x="4665600" y="1122480"/>
            <a:ext cx="131760" cy="618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"/>
          <p:cNvSpPr/>
          <p:nvPr/>
        </p:nvSpPr>
        <p:spPr>
          <a:xfrm flipH="1">
            <a:off x="4809960" y="1138320"/>
            <a:ext cx="114480" cy="603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"/>
          <p:cNvSpPr/>
          <p:nvPr/>
        </p:nvSpPr>
        <p:spPr>
          <a:xfrm>
            <a:off x="4644360" y="927000"/>
            <a:ext cx="610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ITIH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"/>
          <p:cNvSpPr/>
          <p:nvPr/>
        </p:nvSpPr>
        <p:spPr>
          <a:xfrm flipH="1">
            <a:off x="4884480" y="1444680"/>
            <a:ext cx="392040" cy="549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"/>
          <p:cNvSpPr/>
          <p:nvPr/>
        </p:nvSpPr>
        <p:spPr>
          <a:xfrm>
            <a:off x="5029200" y="1157400"/>
            <a:ext cx="63792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O4A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F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"/>
          <p:cNvSpPr/>
          <p:nvPr/>
        </p:nvSpPr>
        <p:spPr>
          <a:xfrm flipH="1">
            <a:off x="5214960" y="1160640"/>
            <a:ext cx="760320" cy="1850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"/>
          <p:cNvSpPr/>
          <p:nvPr/>
        </p:nvSpPr>
        <p:spPr>
          <a:xfrm>
            <a:off x="5923080" y="981000"/>
            <a:ext cx="90612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FIBG,PED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"/>
          <p:cNvSpPr/>
          <p:nvPr/>
        </p:nvSpPr>
        <p:spPr>
          <a:xfrm flipH="1">
            <a:off x="6030720" y="3071880"/>
            <a:ext cx="485640" cy="433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"/>
          <p:cNvSpPr/>
          <p:nvPr/>
        </p:nvSpPr>
        <p:spPr>
          <a:xfrm>
            <a:off x="6463440" y="291456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"/>
          <p:cNvSpPr/>
          <p:nvPr/>
        </p:nvSpPr>
        <p:spPr>
          <a:xfrm>
            <a:off x="2724120" y="4730760"/>
            <a:ext cx="298440" cy="651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"/>
          <p:cNvSpPr/>
          <p:nvPr/>
        </p:nvSpPr>
        <p:spPr>
          <a:xfrm flipV="1">
            <a:off x="2735280" y="4884480"/>
            <a:ext cx="449280" cy="20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"/>
          <p:cNvSpPr/>
          <p:nvPr/>
        </p:nvSpPr>
        <p:spPr>
          <a:xfrm>
            <a:off x="2148480" y="462456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"/>
          <p:cNvSpPr/>
          <p:nvPr/>
        </p:nvSpPr>
        <p:spPr>
          <a:xfrm>
            <a:off x="4309920" y="4875120"/>
            <a:ext cx="40968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"/>
          <p:cNvSpPr/>
          <p:nvPr/>
        </p:nvSpPr>
        <p:spPr>
          <a:xfrm>
            <a:off x="3762360" y="4784760"/>
            <a:ext cx="6210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RET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"/>
          <p:cNvSpPr/>
          <p:nvPr/>
        </p:nvSpPr>
        <p:spPr>
          <a:xfrm flipV="1">
            <a:off x="4862520" y="5162040"/>
            <a:ext cx="214200" cy="427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"/>
          <p:cNvSpPr/>
          <p:nvPr/>
        </p:nvSpPr>
        <p:spPr>
          <a:xfrm>
            <a:off x="4572720" y="5575320"/>
            <a:ext cx="56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PT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"/>
          <p:cNvSpPr/>
          <p:nvPr/>
        </p:nvSpPr>
        <p:spPr>
          <a:xfrm flipH="1" flipV="1">
            <a:off x="5767560" y="5181480"/>
            <a:ext cx="242640" cy="40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"/>
          <p:cNvSpPr/>
          <p:nvPr/>
        </p:nvSpPr>
        <p:spPr>
          <a:xfrm>
            <a:off x="5941080" y="5519880"/>
            <a:ext cx="5648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"/>
          <p:cNvSpPr/>
          <p:nvPr/>
        </p:nvSpPr>
        <p:spPr>
          <a:xfrm flipV="1">
            <a:off x="6427800" y="5186520"/>
            <a:ext cx="201600" cy="404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"/>
          <p:cNvSpPr/>
          <p:nvPr/>
        </p:nvSpPr>
        <p:spPr>
          <a:xfrm flipH="1">
            <a:off x="6108840" y="3683160"/>
            <a:ext cx="303120" cy="1746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"/>
          <p:cNvSpPr/>
          <p:nvPr/>
        </p:nvSpPr>
        <p:spPr>
          <a:xfrm>
            <a:off x="6362640" y="3524400"/>
            <a:ext cx="692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"/>
          <p:cNvSpPr/>
          <p:nvPr/>
        </p:nvSpPr>
        <p:spPr>
          <a:xfrm flipH="1">
            <a:off x="6049800" y="4044960"/>
            <a:ext cx="316080" cy="22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"/>
          <p:cNvSpPr/>
          <p:nvPr/>
        </p:nvSpPr>
        <p:spPr>
          <a:xfrm>
            <a:off x="6320160" y="3884760"/>
            <a:ext cx="622800" cy="33732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TTHY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AM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"/>
          <p:cNvSpPr/>
          <p:nvPr/>
        </p:nvSpPr>
        <p:spPr>
          <a:xfrm>
            <a:off x="2042640" y="4378320"/>
            <a:ext cx="6440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"/>
          <p:cNvSpPr/>
          <p:nvPr/>
        </p:nvSpPr>
        <p:spPr>
          <a:xfrm flipV="1">
            <a:off x="2406600" y="4280040"/>
            <a:ext cx="182520" cy="131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"/>
          <p:cNvSpPr/>
          <p:nvPr/>
        </p:nvSpPr>
        <p:spPr>
          <a:xfrm flipV="1">
            <a:off x="2693880" y="3265200"/>
            <a:ext cx="738360" cy="500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"/>
          <p:cNvSpPr/>
          <p:nvPr/>
        </p:nvSpPr>
        <p:spPr>
          <a:xfrm>
            <a:off x="2128680" y="36910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2G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"/>
          <p:cNvSpPr/>
          <p:nvPr/>
        </p:nvSpPr>
        <p:spPr>
          <a:xfrm flipH="1" flipV="1">
            <a:off x="4334040" y="3490920"/>
            <a:ext cx="93600" cy="139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"/>
          <p:cNvSpPr/>
          <p:nvPr/>
        </p:nvSpPr>
        <p:spPr>
          <a:xfrm>
            <a:off x="4282920" y="361008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ZA2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"/>
          <p:cNvSpPr/>
          <p:nvPr/>
        </p:nvSpPr>
        <p:spPr>
          <a:xfrm flipV="1">
            <a:off x="4600440" y="3947760"/>
            <a:ext cx="133560" cy="560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"/>
          <p:cNvSpPr/>
          <p:nvPr/>
        </p:nvSpPr>
        <p:spPr>
          <a:xfrm>
            <a:off x="3772080" y="4452840"/>
            <a:ext cx="9669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,AM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"/>
          <p:cNvSpPr/>
          <p:nvPr/>
        </p:nvSpPr>
        <p:spPr>
          <a:xfrm flipV="1">
            <a:off x="4284720" y="3904920"/>
            <a:ext cx="133200" cy="297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"/>
          <p:cNvSpPr/>
          <p:nvPr/>
        </p:nvSpPr>
        <p:spPr>
          <a:xfrm>
            <a:off x="3909240" y="415440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"/>
          <p:cNvSpPr/>
          <p:nvPr/>
        </p:nvSpPr>
        <p:spPr>
          <a:xfrm>
            <a:off x="2655720" y="2889360"/>
            <a:ext cx="250920" cy="266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"/>
          <p:cNvSpPr/>
          <p:nvPr/>
        </p:nvSpPr>
        <p:spPr>
          <a:xfrm flipV="1">
            <a:off x="2719440" y="3198960"/>
            <a:ext cx="234720" cy="288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"/>
          <p:cNvSpPr/>
          <p:nvPr/>
        </p:nvSpPr>
        <p:spPr>
          <a:xfrm>
            <a:off x="2233440" y="2673360"/>
            <a:ext cx="700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A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"/>
          <p:cNvSpPr/>
          <p:nvPr/>
        </p:nvSpPr>
        <p:spPr>
          <a:xfrm>
            <a:off x="2071440" y="3414600"/>
            <a:ext cx="7048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C4BP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"/>
          <p:cNvSpPr/>
          <p:nvPr/>
        </p:nvSpPr>
        <p:spPr>
          <a:xfrm>
            <a:off x="3879720" y="2208240"/>
            <a:ext cx="5040" cy="5349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"/>
          <p:cNvSpPr/>
          <p:nvPr/>
        </p:nvSpPr>
        <p:spPr>
          <a:xfrm>
            <a:off x="3541680" y="2030400"/>
            <a:ext cx="62568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"/>
          <p:cNvSpPr/>
          <p:nvPr/>
        </p:nvSpPr>
        <p:spPr>
          <a:xfrm flipH="1">
            <a:off x="5443200" y="2583000"/>
            <a:ext cx="947880" cy="620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"/>
          <p:cNvSpPr/>
          <p:nvPr/>
        </p:nvSpPr>
        <p:spPr>
          <a:xfrm>
            <a:off x="6367680" y="2394000"/>
            <a:ext cx="729360" cy="337320"/>
          </a:xfrm>
          <a:prstGeom prst="rect">
            <a:avLst/>
          </a:prstGeom>
          <a:solidFill>
            <a:srgbClr val="f8f8f8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LBU,HP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"/>
          <p:cNvSpPr/>
          <p:nvPr/>
        </p:nvSpPr>
        <p:spPr>
          <a:xfrm flipH="1">
            <a:off x="5719320" y="3402000"/>
            <a:ext cx="693720" cy="5508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"/>
          <p:cNvSpPr/>
          <p:nvPr/>
        </p:nvSpPr>
        <p:spPr>
          <a:xfrm>
            <a:off x="6365520" y="3284640"/>
            <a:ext cx="6501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APOE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"/>
          <p:cNvSpPr/>
          <p:nvPr/>
        </p:nvSpPr>
        <p:spPr>
          <a:xfrm>
            <a:off x="3768840" y="1122480"/>
            <a:ext cx="250560" cy="5936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"/>
          <p:cNvSpPr/>
          <p:nvPr/>
        </p:nvSpPr>
        <p:spPr>
          <a:xfrm>
            <a:off x="3344400" y="955800"/>
            <a:ext cx="56628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TIH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1A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"/>
          <p:cNvSpPr/>
          <p:nvPr/>
        </p:nvSpPr>
        <p:spPr>
          <a:xfrm flipH="1">
            <a:off x="5751000" y="2152800"/>
            <a:ext cx="530280" cy="622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"/>
          <p:cNvSpPr/>
          <p:nvPr/>
        </p:nvSpPr>
        <p:spPr>
          <a:xfrm>
            <a:off x="6227640" y="2027160"/>
            <a:ext cx="936720" cy="33732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V304,HV30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"/>
          <p:cNvSpPr/>
          <p:nvPr/>
        </p:nvSpPr>
        <p:spPr>
          <a:xfrm>
            <a:off x="4375080" y="1168560"/>
            <a:ext cx="547920" cy="20397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"/>
          <p:cNvSpPr/>
          <p:nvPr/>
        </p:nvSpPr>
        <p:spPr>
          <a:xfrm>
            <a:off x="3982680" y="955800"/>
            <a:ext cx="6501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SHBG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"/>
          <p:cNvSpPr/>
          <p:nvPr/>
        </p:nvSpPr>
        <p:spPr>
          <a:xfrm flipH="1">
            <a:off x="5214600" y="1440000"/>
            <a:ext cx="933480" cy="177300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"/>
          <p:cNvSpPr/>
          <p:nvPr/>
        </p:nvSpPr>
        <p:spPr>
          <a:xfrm>
            <a:off x="6086160" y="1268280"/>
            <a:ext cx="586080" cy="215640"/>
          </a:xfrm>
          <a:prstGeom prst="rect">
            <a:avLst/>
          </a:prstGeom>
          <a:solidFill>
            <a:srgbClr val="f8f8f8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D5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"/>
          <p:cNvSpPr/>
          <p:nvPr/>
        </p:nvSpPr>
        <p:spPr>
          <a:xfrm>
            <a:off x="2725560" y="5249880"/>
            <a:ext cx="211320" cy="32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"/>
          <p:cNvSpPr/>
          <p:nvPr/>
        </p:nvSpPr>
        <p:spPr>
          <a:xfrm>
            <a:off x="2395080" y="5145120"/>
            <a:ext cx="3942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"/>
          <p:cNvSpPr/>
          <p:nvPr/>
        </p:nvSpPr>
        <p:spPr>
          <a:xfrm>
            <a:off x="6056280" y="1689120"/>
            <a:ext cx="1008000" cy="215640"/>
          </a:xfrm>
          <a:prstGeom prst="rect">
            <a:avLst/>
          </a:prstGeom>
          <a:solidFill>
            <a:srgbClr val="f8f8f8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D5L,ALBU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"/>
          <p:cNvSpPr/>
          <p:nvPr/>
        </p:nvSpPr>
        <p:spPr>
          <a:xfrm flipH="1">
            <a:off x="5214600" y="1828800"/>
            <a:ext cx="909720" cy="1509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"/>
          <p:cNvSpPr/>
          <p:nvPr/>
        </p:nvSpPr>
        <p:spPr>
          <a:xfrm flipV="1">
            <a:off x="5303880" y="4184640"/>
            <a:ext cx="298440" cy="15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"/>
          <p:cNvSpPr/>
          <p:nvPr/>
        </p:nvSpPr>
        <p:spPr>
          <a:xfrm>
            <a:off x="4816800" y="3852720"/>
            <a:ext cx="84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KC,LAC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IPO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"/>
          <p:cNvSpPr/>
          <p:nvPr/>
        </p:nvSpPr>
        <p:spPr>
          <a:xfrm flipH="1" flipV="1">
            <a:off x="5438520" y="5238360"/>
            <a:ext cx="73080" cy="2350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"/>
          <p:cNvSpPr/>
          <p:nvPr/>
        </p:nvSpPr>
        <p:spPr>
          <a:xfrm>
            <a:off x="5214960" y="5445000"/>
            <a:ext cx="63180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H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"/>
          <p:cNvSpPr/>
          <p:nvPr/>
        </p:nvSpPr>
        <p:spPr>
          <a:xfrm>
            <a:off x="2158200" y="497520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"/>
          <p:cNvSpPr/>
          <p:nvPr/>
        </p:nvSpPr>
        <p:spPr>
          <a:xfrm>
            <a:off x="2158200" y="4830840"/>
            <a:ext cx="666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HEMO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"/>
          <p:cNvSpPr/>
          <p:nvPr/>
        </p:nvSpPr>
        <p:spPr>
          <a:xfrm flipV="1">
            <a:off x="2733840" y="4870440"/>
            <a:ext cx="280800" cy="47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"/>
          <p:cNvSpPr/>
          <p:nvPr/>
        </p:nvSpPr>
        <p:spPr>
          <a:xfrm>
            <a:off x="3290760" y="4991040"/>
            <a:ext cx="4856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"/>
          <p:cNvSpPr/>
          <p:nvPr/>
        </p:nvSpPr>
        <p:spPr>
          <a:xfrm flipH="1" flipV="1">
            <a:off x="3327120" y="4781520"/>
            <a:ext cx="73080" cy="249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"/>
          <p:cNvSpPr/>
          <p:nvPr/>
        </p:nvSpPr>
        <p:spPr>
          <a:xfrm flipH="1" flipV="1">
            <a:off x="3443040" y="4465800"/>
            <a:ext cx="50760" cy="5443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"/>
          <p:cNvSpPr/>
          <p:nvPr/>
        </p:nvSpPr>
        <p:spPr>
          <a:xfrm>
            <a:off x="3271680" y="4241880"/>
            <a:ext cx="51120" cy="1951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9" name=""/>
          <p:cNvSpPr/>
          <p:nvPr/>
        </p:nvSpPr>
        <p:spPr>
          <a:xfrm flipH="1">
            <a:off x="3206520" y="4240080"/>
            <a:ext cx="20520" cy="1825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"/>
          <p:cNvSpPr/>
          <p:nvPr/>
        </p:nvSpPr>
        <p:spPr>
          <a:xfrm flipH="1">
            <a:off x="3116160" y="4221000"/>
            <a:ext cx="60480" cy="1778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"/>
          <p:cNvSpPr/>
          <p:nvPr/>
        </p:nvSpPr>
        <p:spPr>
          <a:xfrm>
            <a:off x="2955960" y="4076640"/>
            <a:ext cx="52524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J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"/>
          <p:cNvSpPr/>
          <p:nvPr/>
        </p:nvSpPr>
        <p:spPr>
          <a:xfrm flipH="1" flipV="1">
            <a:off x="5887800" y="4384440"/>
            <a:ext cx="291960" cy="2458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"/>
          <p:cNvSpPr/>
          <p:nvPr/>
        </p:nvSpPr>
        <p:spPr>
          <a:xfrm>
            <a:off x="6066360" y="4613400"/>
            <a:ext cx="1006560" cy="45900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204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AC,KV203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V302,KV402,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"/>
          <p:cNvSpPr/>
          <p:nvPr/>
        </p:nvSpPr>
        <p:spPr>
          <a:xfrm>
            <a:off x="3970800" y="5084640"/>
            <a:ext cx="1006560" cy="33732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IGHA1,KV101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V121,APOA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"/>
          <p:cNvSpPr/>
          <p:nvPr/>
        </p:nvSpPr>
        <p:spPr>
          <a:xfrm flipV="1">
            <a:off x="4844880" y="4479480"/>
            <a:ext cx="128880" cy="6526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6" name=""/>
          <p:cNvSpPr/>
          <p:nvPr/>
        </p:nvSpPr>
        <p:spPr>
          <a:xfrm flipV="1">
            <a:off x="3900600" y="1778040"/>
            <a:ext cx="274680" cy="27936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"/>
          <p:cNvSpPr/>
          <p:nvPr/>
        </p:nvSpPr>
        <p:spPr>
          <a:xfrm flipH="1" flipV="1">
            <a:off x="3603600" y="4201920"/>
            <a:ext cx="162000" cy="4460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"/>
          <p:cNvSpPr/>
          <p:nvPr/>
        </p:nvSpPr>
        <p:spPr>
          <a:xfrm>
            <a:off x="3494880" y="4605480"/>
            <a:ext cx="6487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1433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"/>
          <p:cNvSpPr/>
          <p:nvPr/>
        </p:nvSpPr>
        <p:spPr>
          <a:xfrm flipV="1">
            <a:off x="2824200" y="3519000"/>
            <a:ext cx="969840" cy="47628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"/>
          <p:cNvSpPr/>
          <p:nvPr/>
        </p:nvSpPr>
        <p:spPr>
          <a:xfrm>
            <a:off x="2345040" y="3935520"/>
            <a:ext cx="5695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"/>
          <p:cNvSpPr/>
          <p:nvPr/>
        </p:nvSpPr>
        <p:spPr>
          <a:xfrm flipV="1">
            <a:off x="3638520" y="3578400"/>
            <a:ext cx="476280" cy="23472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"/>
          <p:cNvSpPr/>
          <p:nvPr/>
        </p:nvSpPr>
        <p:spPr>
          <a:xfrm>
            <a:off x="3357720" y="3781440"/>
            <a:ext cx="52956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(CO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"/>
          <p:cNvSpPr/>
          <p:nvPr/>
        </p:nvSpPr>
        <p:spPr>
          <a:xfrm flipH="1" flipV="1">
            <a:off x="5009760" y="3687480"/>
            <a:ext cx="282600" cy="28440"/>
          </a:xfrm>
          <a:prstGeom prst="line">
            <a:avLst/>
          </a:prstGeom>
          <a:ln w="15840">
            <a:solidFill>
              <a:srgbClr val="ffffff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"/>
          <p:cNvSpPr/>
          <p:nvPr/>
        </p:nvSpPr>
        <p:spPr>
          <a:xfrm>
            <a:off x="5230080" y="3611520"/>
            <a:ext cx="637920" cy="215640"/>
          </a:xfrm>
          <a:prstGeom prst="rect">
            <a:avLst/>
          </a:prstGeom>
          <a:solidFill>
            <a:srgbClr val="f8f8f8">
              <a:alpha val="1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*(CLU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03T19:38:23Z</dcterms:created>
  <dc:creator>bevin</dc:creator>
  <dc:description/>
  <dc:language>en-US</dc:language>
  <cp:lastModifiedBy>bevin</cp:lastModifiedBy>
  <dcterms:modified xsi:type="dcterms:W3CDTF">2012-05-31T14:58:02Z</dcterms:modified>
  <cp:revision>49</cp:revision>
  <dc:subject/>
  <dc:title>Slide 1</dc:title>
</cp:coreProperties>
</file>